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7" Type="http://schemas.microsoft.com/office/2020/02/relationships/classificationlabels" Target="docMetadata/LabelInfo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</p:sldIdLst>
  <p:sldSz cx="11898313" cy="13147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A9"/>
    <a:srgbClr val="F4F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854" autoAdjust="0"/>
    <p:restoredTop sz="94640"/>
  </p:normalViewPr>
  <p:slideViewPr>
    <p:cSldViewPr snapToGrid="0">
      <p:cViewPr>
        <p:scale>
          <a:sx n="100" d="100"/>
          <a:sy n="100" d="100"/>
        </p:scale>
        <p:origin x="18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2374" y="2151715"/>
            <a:ext cx="10113566" cy="4577339"/>
          </a:xfrm>
        </p:spPr>
        <p:txBody>
          <a:bodyPr anchor="b"/>
          <a:lstStyle>
            <a:lvl1pPr algn="ctr">
              <a:defRPr sz="780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7289" y="6905574"/>
            <a:ext cx="8923735" cy="3174310"/>
          </a:xfrm>
        </p:spPr>
        <p:txBody>
          <a:bodyPr/>
          <a:lstStyle>
            <a:lvl1pPr marL="0" indent="0" algn="ctr">
              <a:buNone/>
              <a:defRPr sz="3123"/>
            </a:lvl1pPr>
            <a:lvl2pPr marL="594909" indent="0" algn="ctr">
              <a:buNone/>
              <a:defRPr sz="2602"/>
            </a:lvl2pPr>
            <a:lvl3pPr marL="1189817" indent="0" algn="ctr">
              <a:buNone/>
              <a:defRPr sz="2342"/>
            </a:lvl3pPr>
            <a:lvl4pPr marL="1784726" indent="0" algn="ctr">
              <a:buNone/>
              <a:defRPr sz="2082"/>
            </a:lvl4pPr>
            <a:lvl5pPr marL="2379635" indent="0" algn="ctr">
              <a:buNone/>
              <a:defRPr sz="2082"/>
            </a:lvl5pPr>
            <a:lvl6pPr marL="2974543" indent="0" algn="ctr">
              <a:buNone/>
              <a:defRPr sz="2082"/>
            </a:lvl6pPr>
            <a:lvl7pPr marL="3569452" indent="0" algn="ctr">
              <a:buNone/>
              <a:defRPr sz="2082"/>
            </a:lvl7pPr>
            <a:lvl8pPr marL="4164360" indent="0" algn="ctr">
              <a:buNone/>
              <a:defRPr sz="2082"/>
            </a:lvl8pPr>
            <a:lvl9pPr marL="4759269" indent="0" algn="ctr">
              <a:buNone/>
              <a:defRPr sz="2082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587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397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14731" y="699992"/>
            <a:ext cx="2565574" cy="1114204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8010" y="699992"/>
            <a:ext cx="7547992" cy="1114204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452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8362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813" y="3277792"/>
            <a:ext cx="10262295" cy="5469067"/>
          </a:xfrm>
        </p:spPr>
        <p:txBody>
          <a:bodyPr anchor="b"/>
          <a:lstStyle>
            <a:lvl1pPr>
              <a:defRPr sz="780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813" y="8798598"/>
            <a:ext cx="10262295" cy="2876053"/>
          </a:xfrm>
        </p:spPr>
        <p:txBody>
          <a:bodyPr/>
          <a:lstStyle>
            <a:lvl1pPr marL="0" indent="0">
              <a:buNone/>
              <a:defRPr sz="3123">
                <a:solidFill>
                  <a:schemeClr val="tx1">
                    <a:tint val="82000"/>
                  </a:schemeClr>
                </a:solidFill>
              </a:defRPr>
            </a:lvl1pPr>
            <a:lvl2pPr marL="594909" indent="0">
              <a:buNone/>
              <a:defRPr sz="2602">
                <a:solidFill>
                  <a:schemeClr val="tx1">
                    <a:tint val="82000"/>
                  </a:schemeClr>
                </a:solidFill>
              </a:defRPr>
            </a:lvl2pPr>
            <a:lvl3pPr marL="1189817" indent="0">
              <a:buNone/>
              <a:defRPr sz="2342">
                <a:solidFill>
                  <a:schemeClr val="tx1">
                    <a:tint val="82000"/>
                  </a:schemeClr>
                </a:solidFill>
              </a:defRPr>
            </a:lvl3pPr>
            <a:lvl4pPr marL="1784726" indent="0">
              <a:buNone/>
              <a:defRPr sz="2082">
                <a:solidFill>
                  <a:schemeClr val="tx1">
                    <a:tint val="82000"/>
                  </a:schemeClr>
                </a:solidFill>
              </a:defRPr>
            </a:lvl4pPr>
            <a:lvl5pPr marL="2379635" indent="0">
              <a:buNone/>
              <a:defRPr sz="2082">
                <a:solidFill>
                  <a:schemeClr val="tx1">
                    <a:tint val="82000"/>
                  </a:schemeClr>
                </a:solidFill>
              </a:defRPr>
            </a:lvl5pPr>
            <a:lvl6pPr marL="2974543" indent="0">
              <a:buNone/>
              <a:defRPr sz="2082">
                <a:solidFill>
                  <a:schemeClr val="tx1">
                    <a:tint val="82000"/>
                  </a:schemeClr>
                </a:solidFill>
              </a:defRPr>
            </a:lvl6pPr>
            <a:lvl7pPr marL="3569452" indent="0">
              <a:buNone/>
              <a:defRPr sz="2082">
                <a:solidFill>
                  <a:schemeClr val="tx1">
                    <a:tint val="82000"/>
                  </a:schemeClr>
                </a:solidFill>
              </a:defRPr>
            </a:lvl7pPr>
            <a:lvl8pPr marL="4164360" indent="0">
              <a:buNone/>
              <a:defRPr sz="2082">
                <a:solidFill>
                  <a:schemeClr val="tx1">
                    <a:tint val="82000"/>
                  </a:schemeClr>
                </a:solidFill>
              </a:defRPr>
            </a:lvl8pPr>
            <a:lvl9pPr marL="4759269" indent="0">
              <a:buNone/>
              <a:defRPr sz="208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081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8009" y="3499960"/>
            <a:ext cx="5056783" cy="83420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23521" y="3499960"/>
            <a:ext cx="5056783" cy="83420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824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9559" y="699995"/>
            <a:ext cx="10262295" cy="254127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9560" y="3223007"/>
            <a:ext cx="5033543" cy="1579546"/>
          </a:xfrm>
        </p:spPr>
        <p:txBody>
          <a:bodyPr anchor="b"/>
          <a:lstStyle>
            <a:lvl1pPr marL="0" indent="0">
              <a:buNone/>
              <a:defRPr sz="3123" b="1"/>
            </a:lvl1pPr>
            <a:lvl2pPr marL="594909" indent="0">
              <a:buNone/>
              <a:defRPr sz="2602" b="1"/>
            </a:lvl2pPr>
            <a:lvl3pPr marL="1189817" indent="0">
              <a:buNone/>
              <a:defRPr sz="2342" b="1"/>
            </a:lvl3pPr>
            <a:lvl4pPr marL="1784726" indent="0">
              <a:buNone/>
              <a:defRPr sz="2082" b="1"/>
            </a:lvl4pPr>
            <a:lvl5pPr marL="2379635" indent="0">
              <a:buNone/>
              <a:defRPr sz="2082" b="1"/>
            </a:lvl5pPr>
            <a:lvl6pPr marL="2974543" indent="0">
              <a:buNone/>
              <a:defRPr sz="2082" b="1"/>
            </a:lvl6pPr>
            <a:lvl7pPr marL="3569452" indent="0">
              <a:buNone/>
              <a:defRPr sz="2082" b="1"/>
            </a:lvl7pPr>
            <a:lvl8pPr marL="4164360" indent="0">
              <a:buNone/>
              <a:defRPr sz="2082" b="1"/>
            </a:lvl8pPr>
            <a:lvl9pPr marL="4759269" indent="0">
              <a:buNone/>
              <a:defRPr sz="208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9560" y="4802553"/>
            <a:ext cx="5033543" cy="70638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23521" y="3223007"/>
            <a:ext cx="5058333" cy="1579546"/>
          </a:xfrm>
        </p:spPr>
        <p:txBody>
          <a:bodyPr anchor="b"/>
          <a:lstStyle>
            <a:lvl1pPr marL="0" indent="0">
              <a:buNone/>
              <a:defRPr sz="3123" b="1"/>
            </a:lvl1pPr>
            <a:lvl2pPr marL="594909" indent="0">
              <a:buNone/>
              <a:defRPr sz="2602" b="1"/>
            </a:lvl2pPr>
            <a:lvl3pPr marL="1189817" indent="0">
              <a:buNone/>
              <a:defRPr sz="2342" b="1"/>
            </a:lvl3pPr>
            <a:lvl4pPr marL="1784726" indent="0">
              <a:buNone/>
              <a:defRPr sz="2082" b="1"/>
            </a:lvl4pPr>
            <a:lvl5pPr marL="2379635" indent="0">
              <a:buNone/>
              <a:defRPr sz="2082" b="1"/>
            </a:lvl5pPr>
            <a:lvl6pPr marL="2974543" indent="0">
              <a:buNone/>
              <a:defRPr sz="2082" b="1"/>
            </a:lvl6pPr>
            <a:lvl7pPr marL="3569452" indent="0">
              <a:buNone/>
              <a:defRPr sz="2082" b="1"/>
            </a:lvl7pPr>
            <a:lvl8pPr marL="4164360" indent="0">
              <a:buNone/>
              <a:defRPr sz="2082" b="1"/>
            </a:lvl8pPr>
            <a:lvl9pPr marL="4759269" indent="0">
              <a:buNone/>
              <a:defRPr sz="208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23521" y="4802553"/>
            <a:ext cx="5058333" cy="70638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482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6534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6423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9559" y="876512"/>
            <a:ext cx="3837516" cy="3067791"/>
          </a:xfrm>
        </p:spPr>
        <p:txBody>
          <a:bodyPr anchor="b"/>
          <a:lstStyle>
            <a:lvl1pPr>
              <a:defRPr sz="416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8333" y="1893025"/>
            <a:ext cx="6023521" cy="9343371"/>
          </a:xfrm>
        </p:spPr>
        <p:txBody>
          <a:bodyPr/>
          <a:lstStyle>
            <a:lvl1pPr>
              <a:defRPr sz="4164"/>
            </a:lvl1pPr>
            <a:lvl2pPr>
              <a:defRPr sz="3643"/>
            </a:lvl2pPr>
            <a:lvl3pPr>
              <a:defRPr sz="3123"/>
            </a:lvl3pPr>
            <a:lvl4pPr>
              <a:defRPr sz="2602"/>
            </a:lvl4pPr>
            <a:lvl5pPr>
              <a:defRPr sz="2602"/>
            </a:lvl5pPr>
            <a:lvl6pPr>
              <a:defRPr sz="2602"/>
            </a:lvl6pPr>
            <a:lvl7pPr>
              <a:defRPr sz="2602"/>
            </a:lvl7pPr>
            <a:lvl8pPr>
              <a:defRPr sz="2602"/>
            </a:lvl8pPr>
            <a:lvl9pPr>
              <a:defRPr sz="2602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9559" y="3944303"/>
            <a:ext cx="3837516" cy="7307308"/>
          </a:xfrm>
        </p:spPr>
        <p:txBody>
          <a:bodyPr/>
          <a:lstStyle>
            <a:lvl1pPr marL="0" indent="0">
              <a:buNone/>
              <a:defRPr sz="2082"/>
            </a:lvl1pPr>
            <a:lvl2pPr marL="594909" indent="0">
              <a:buNone/>
              <a:defRPr sz="1822"/>
            </a:lvl2pPr>
            <a:lvl3pPr marL="1189817" indent="0">
              <a:buNone/>
              <a:defRPr sz="1561"/>
            </a:lvl3pPr>
            <a:lvl4pPr marL="1784726" indent="0">
              <a:buNone/>
              <a:defRPr sz="1301"/>
            </a:lvl4pPr>
            <a:lvl5pPr marL="2379635" indent="0">
              <a:buNone/>
              <a:defRPr sz="1301"/>
            </a:lvl5pPr>
            <a:lvl6pPr marL="2974543" indent="0">
              <a:buNone/>
              <a:defRPr sz="1301"/>
            </a:lvl6pPr>
            <a:lvl7pPr marL="3569452" indent="0">
              <a:buNone/>
              <a:defRPr sz="1301"/>
            </a:lvl7pPr>
            <a:lvl8pPr marL="4164360" indent="0">
              <a:buNone/>
              <a:defRPr sz="1301"/>
            </a:lvl8pPr>
            <a:lvl9pPr marL="4759269" indent="0">
              <a:buNone/>
              <a:defRPr sz="130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1052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9559" y="876512"/>
            <a:ext cx="3837516" cy="3067791"/>
          </a:xfrm>
        </p:spPr>
        <p:txBody>
          <a:bodyPr anchor="b"/>
          <a:lstStyle>
            <a:lvl1pPr>
              <a:defRPr sz="416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8333" y="1893025"/>
            <a:ext cx="6023521" cy="9343371"/>
          </a:xfrm>
        </p:spPr>
        <p:txBody>
          <a:bodyPr anchor="t"/>
          <a:lstStyle>
            <a:lvl1pPr marL="0" indent="0">
              <a:buNone/>
              <a:defRPr sz="4164"/>
            </a:lvl1pPr>
            <a:lvl2pPr marL="594909" indent="0">
              <a:buNone/>
              <a:defRPr sz="3643"/>
            </a:lvl2pPr>
            <a:lvl3pPr marL="1189817" indent="0">
              <a:buNone/>
              <a:defRPr sz="3123"/>
            </a:lvl3pPr>
            <a:lvl4pPr marL="1784726" indent="0">
              <a:buNone/>
              <a:defRPr sz="2602"/>
            </a:lvl4pPr>
            <a:lvl5pPr marL="2379635" indent="0">
              <a:buNone/>
              <a:defRPr sz="2602"/>
            </a:lvl5pPr>
            <a:lvl6pPr marL="2974543" indent="0">
              <a:buNone/>
              <a:defRPr sz="2602"/>
            </a:lvl6pPr>
            <a:lvl7pPr marL="3569452" indent="0">
              <a:buNone/>
              <a:defRPr sz="2602"/>
            </a:lvl7pPr>
            <a:lvl8pPr marL="4164360" indent="0">
              <a:buNone/>
              <a:defRPr sz="2602"/>
            </a:lvl8pPr>
            <a:lvl9pPr marL="4759269" indent="0">
              <a:buNone/>
              <a:defRPr sz="2602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9559" y="3944303"/>
            <a:ext cx="3837516" cy="7307308"/>
          </a:xfrm>
        </p:spPr>
        <p:txBody>
          <a:bodyPr/>
          <a:lstStyle>
            <a:lvl1pPr marL="0" indent="0">
              <a:buNone/>
              <a:defRPr sz="2082"/>
            </a:lvl1pPr>
            <a:lvl2pPr marL="594909" indent="0">
              <a:buNone/>
              <a:defRPr sz="1822"/>
            </a:lvl2pPr>
            <a:lvl3pPr marL="1189817" indent="0">
              <a:buNone/>
              <a:defRPr sz="1561"/>
            </a:lvl3pPr>
            <a:lvl4pPr marL="1784726" indent="0">
              <a:buNone/>
              <a:defRPr sz="1301"/>
            </a:lvl4pPr>
            <a:lvl5pPr marL="2379635" indent="0">
              <a:buNone/>
              <a:defRPr sz="1301"/>
            </a:lvl5pPr>
            <a:lvl6pPr marL="2974543" indent="0">
              <a:buNone/>
              <a:defRPr sz="1301"/>
            </a:lvl6pPr>
            <a:lvl7pPr marL="3569452" indent="0">
              <a:buNone/>
              <a:defRPr sz="1301"/>
            </a:lvl7pPr>
            <a:lvl8pPr marL="4164360" indent="0">
              <a:buNone/>
              <a:defRPr sz="1301"/>
            </a:lvl8pPr>
            <a:lvl9pPr marL="4759269" indent="0">
              <a:buNone/>
              <a:defRPr sz="130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201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8009" y="699995"/>
            <a:ext cx="10262295" cy="25412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009" y="3499960"/>
            <a:ext cx="10262295" cy="8342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8009" y="12185950"/>
            <a:ext cx="2677120" cy="699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B6F3A3-EE43-4481-BA66-69D6F12E1E05}" type="datetimeFigureOut">
              <a:rPr lang="en-GB" smtClean="0"/>
              <a:t>08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41316" y="12185950"/>
            <a:ext cx="4015681" cy="699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403184" y="12185950"/>
            <a:ext cx="2677120" cy="699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B8EA4D-A631-40A5-ABC8-672422A71F93}" type="slidenum">
              <a:rPr lang="en-GB" smtClean="0"/>
              <a:t>‹#›</a:t>
            </a:fld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92B4659-96C2-ABD9-31E5-C9338A41BD52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9832633" y="84280"/>
            <a:ext cx="2005086" cy="153888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GB" sz="10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UBLIC / CYHOEDDUS</a:t>
            </a:r>
          </a:p>
        </p:txBody>
      </p:sp>
    </p:spTree>
    <p:extLst>
      <p:ext uri="{BB962C8B-B14F-4D97-AF65-F5344CB8AC3E}">
        <p14:creationId xmlns:p14="http://schemas.microsoft.com/office/powerpoint/2010/main" val="3154663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189817" rtl="0" eaLnBrk="1" latinLnBrk="0" hangingPunct="1">
        <a:lnSpc>
          <a:spcPct val="90000"/>
        </a:lnSpc>
        <a:spcBef>
          <a:spcPct val="0"/>
        </a:spcBef>
        <a:buNone/>
        <a:defRPr sz="57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454" indent="-297454" algn="l" defTabSz="1189817" rtl="0" eaLnBrk="1" latinLnBrk="0" hangingPunct="1">
        <a:lnSpc>
          <a:spcPct val="90000"/>
        </a:lnSpc>
        <a:spcBef>
          <a:spcPts val="1301"/>
        </a:spcBef>
        <a:buFont typeface="Arial" panose="020B0604020202020204" pitchFamily="34" charset="0"/>
        <a:buChar char="•"/>
        <a:defRPr sz="3643" kern="1200">
          <a:solidFill>
            <a:schemeClr val="tx1"/>
          </a:solidFill>
          <a:latin typeface="+mn-lt"/>
          <a:ea typeface="+mn-ea"/>
          <a:cs typeface="+mn-cs"/>
        </a:defRPr>
      </a:lvl1pPr>
      <a:lvl2pPr marL="892363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3123" kern="1200">
          <a:solidFill>
            <a:schemeClr val="tx1"/>
          </a:solidFill>
          <a:latin typeface="+mn-lt"/>
          <a:ea typeface="+mn-ea"/>
          <a:cs typeface="+mn-cs"/>
        </a:defRPr>
      </a:lvl2pPr>
      <a:lvl3pPr marL="1487272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602" kern="1200">
          <a:solidFill>
            <a:schemeClr val="tx1"/>
          </a:solidFill>
          <a:latin typeface="+mn-lt"/>
          <a:ea typeface="+mn-ea"/>
          <a:cs typeface="+mn-cs"/>
        </a:defRPr>
      </a:lvl3pPr>
      <a:lvl4pPr marL="2082180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342" kern="1200">
          <a:solidFill>
            <a:schemeClr val="tx1"/>
          </a:solidFill>
          <a:latin typeface="+mn-lt"/>
          <a:ea typeface="+mn-ea"/>
          <a:cs typeface="+mn-cs"/>
        </a:defRPr>
      </a:lvl4pPr>
      <a:lvl5pPr marL="2677089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342" kern="1200">
          <a:solidFill>
            <a:schemeClr val="tx1"/>
          </a:solidFill>
          <a:latin typeface="+mn-lt"/>
          <a:ea typeface="+mn-ea"/>
          <a:cs typeface="+mn-cs"/>
        </a:defRPr>
      </a:lvl5pPr>
      <a:lvl6pPr marL="3271998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342" kern="1200">
          <a:solidFill>
            <a:schemeClr val="tx1"/>
          </a:solidFill>
          <a:latin typeface="+mn-lt"/>
          <a:ea typeface="+mn-ea"/>
          <a:cs typeface="+mn-cs"/>
        </a:defRPr>
      </a:lvl6pPr>
      <a:lvl7pPr marL="3866906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342" kern="1200">
          <a:solidFill>
            <a:schemeClr val="tx1"/>
          </a:solidFill>
          <a:latin typeface="+mn-lt"/>
          <a:ea typeface="+mn-ea"/>
          <a:cs typeface="+mn-cs"/>
        </a:defRPr>
      </a:lvl7pPr>
      <a:lvl8pPr marL="4461815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342" kern="1200">
          <a:solidFill>
            <a:schemeClr val="tx1"/>
          </a:solidFill>
          <a:latin typeface="+mn-lt"/>
          <a:ea typeface="+mn-ea"/>
          <a:cs typeface="+mn-cs"/>
        </a:defRPr>
      </a:lvl8pPr>
      <a:lvl9pPr marL="5056723" indent="-297454" algn="l" defTabSz="1189817" rtl="0" eaLnBrk="1" latinLnBrk="0" hangingPunct="1">
        <a:lnSpc>
          <a:spcPct val="90000"/>
        </a:lnSpc>
        <a:spcBef>
          <a:spcPts val="651"/>
        </a:spcBef>
        <a:buFont typeface="Arial" panose="020B0604020202020204" pitchFamily="34" charset="0"/>
        <a:buChar char="•"/>
        <a:defRPr sz="23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1pPr>
      <a:lvl2pPr marL="594909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2pPr>
      <a:lvl3pPr marL="1189817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3pPr>
      <a:lvl4pPr marL="1784726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4pPr>
      <a:lvl5pPr marL="2379635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5pPr>
      <a:lvl6pPr marL="2974543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6pPr>
      <a:lvl7pPr marL="3569452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7pPr>
      <a:lvl8pPr marL="4164360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8pPr>
      <a:lvl9pPr marL="4759269" algn="l" defTabSz="1189817" rtl="0" eaLnBrk="1" latinLnBrk="0" hangingPunct="1">
        <a:defRPr sz="23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Picture 110">
            <a:extLst>
              <a:ext uri="{FF2B5EF4-FFF2-40B4-BE49-F238E27FC236}">
                <a16:creationId xmlns:a16="http://schemas.microsoft.com/office/drawing/2014/main" id="{95E887FB-BD4E-DC60-27A1-101ADD9EAAA0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6846426" y="847960"/>
            <a:ext cx="3752850" cy="306705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91A5AF19-603C-11E2-F75C-12D0EA14ABFD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868148" y="802551"/>
            <a:ext cx="3765550" cy="3073400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AFFB5034-F330-E212-B4AF-EE88C51162C7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827865" y="9426738"/>
            <a:ext cx="3844925" cy="3006725"/>
          </a:xfrm>
          <a:prstGeom prst="rect">
            <a:avLst/>
          </a:prstGeom>
        </p:spPr>
      </p:pic>
      <p:pic>
        <p:nvPicPr>
          <p:cNvPr id="117" name="Picture 116">
            <a:extLst>
              <a:ext uri="{FF2B5EF4-FFF2-40B4-BE49-F238E27FC236}">
                <a16:creationId xmlns:a16="http://schemas.microsoft.com/office/drawing/2014/main" id="{B76D695F-244B-CF48-A2EB-F3D759295488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772085" y="5111034"/>
            <a:ext cx="3879850" cy="30067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BCFE82B-E3D3-B92C-FE2C-D72EBF29E171}"/>
              </a:ext>
            </a:extLst>
          </p:cNvPr>
          <p:cNvSpPr txBox="1"/>
          <p:nvPr/>
        </p:nvSpPr>
        <p:spPr>
          <a:xfrm>
            <a:off x="6167603" y="789103"/>
            <a:ext cx="4539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+mj-lt"/>
              </a:rPr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682A38D-F686-47E6-F929-C25626A06159}"/>
              </a:ext>
            </a:extLst>
          </p:cNvPr>
          <p:cNvSpPr txBox="1"/>
          <p:nvPr/>
        </p:nvSpPr>
        <p:spPr>
          <a:xfrm>
            <a:off x="10722064" y="832176"/>
            <a:ext cx="981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AMS+ (n = 5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C6DCE23-B4B8-F299-C599-5396DC7F8796}"/>
              </a:ext>
            </a:extLst>
          </p:cNvPr>
          <p:cNvSpPr txBox="1"/>
          <p:nvPr/>
        </p:nvSpPr>
        <p:spPr>
          <a:xfrm>
            <a:off x="10718903" y="990908"/>
            <a:ext cx="98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AMS-  (n = 7)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26187B93-F240-066B-F356-5D763979102C}"/>
              </a:ext>
            </a:extLst>
          </p:cNvPr>
          <p:cNvSpPr txBox="1"/>
          <p:nvPr/>
        </p:nvSpPr>
        <p:spPr>
          <a:xfrm>
            <a:off x="8535164" y="3832241"/>
            <a:ext cx="609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Hours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3EC76CCA-AC96-1A97-F19E-305BE9957EF9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672887" y="906908"/>
            <a:ext cx="146050" cy="13335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56ECB442-9D2C-F160-0B77-01BABCB19A8A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670272" y="1050997"/>
            <a:ext cx="139700" cy="14605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BD6526E0-3C09-D5A2-5036-D05B07C40103}"/>
              </a:ext>
            </a:extLst>
          </p:cNvPr>
          <p:cNvSpPr txBox="1"/>
          <p:nvPr/>
        </p:nvSpPr>
        <p:spPr>
          <a:xfrm>
            <a:off x="7062140" y="929644"/>
            <a:ext cx="1679883" cy="520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State: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Time: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State × Time: P = &lt;0.001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FC458112-C9F9-48F1-FA66-DA066F2F8255}"/>
              </a:ext>
            </a:extLst>
          </p:cNvPr>
          <p:cNvCxnSpPr>
            <a:cxnSpLocks/>
          </p:cNvCxnSpPr>
          <p:nvPr/>
        </p:nvCxnSpPr>
        <p:spPr>
          <a:xfrm flipV="1">
            <a:off x="7257506" y="2714168"/>
            <a:ext cx="486513" cy="720788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CB627F5-967F-77B4-7A83-AD195041F8B6}"/>
              </a:ext>
            </a:extLst>
          </p:cNvPr>
          <p:cNvCxnSpPr>
            <a:cxnSpLocks/>
          </p:cNvCxnSpPr>
          <p:nvPr/>
        </p:nvCxnSpPr>
        <p:spPr>
          <a:xfrm>
            <a:off x="7742907" y="2714168"/>
            <a:ext cx="468000" cy="0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F480CE9-0D29-50AB-5403-8C67B83FFCC0}"/>
              </a:ext>
            </a:extLst>
          </p:cNvPr>
          <p:cNvCxnSpPr>
            <a:cxnSpLocks/>
          </p:cNvCxnSpPr>
          <p:nvPr/>
        </p:nvCxnSpPr>
        <p:spPr>
          <a:xfrm flipV="1">
            <a:off x="8228670" y="2401846"/>
            <a:ext cx="486513" cy="305500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6E501B0A-2512-4A28-4737-22715286E28A}"/>
              </a:ext>
            </a:extLst>
          </p:cNvPr>
          <p:cNvCxnSpPr>
            <a:cxnSpLocks/>
          </p:cNvCxnSpPr>
          <p:nvPr/>
        </p:nvCxnSpPr>
        <p:spPr>
          <a:xfrm flipV="1">
            <a:off x="8693881" y="2346957"/>
            <a:ext cx="466227" cy="56329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838372FE-7EBD-F5CD-6880-AD0B89A2A604}"/>
              </a:ext>
            </a:extLst>
          </p:cNvPr>
          <p:cNvCxnSpPr>
            <a:cxnSpLocks/>
          </p:cNvCxnSpPr>
          <p:nvPr/>
        </p:nvCxnSpPr>
        <p:spPr>
          <a:xfrm flipV="1">
            <a:off x="9160108" y="1728454"/>
            <a:ext cx="495373" cy="618503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8CAF6FA-BE90-73FE-CEAD-63391CA66EEC}"/>
              </a:ext>
            </a:extLst>
          </p:cNvPr>
          <p:cNvCxnSpPr>
            <a:cxnSpLocks/>
          </p:cNvCxnSpPr>
          <p:nvPr/>
        </p:nvCxnSpPr>
        <p:spPr>
          <a:xfrm flipV="1">
            <a:off x="9655476" y="1349651"/>
            <a:ext cx="471212" cy="354723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A2DAA054-0400-35A1-539A-7253D83467C3}"/>
              </a:ext>
            </a:extLst>
          </p:cNvPr>
          <p:cNvCxnSpPr>
            <a:cxnSpLocks/>
          </p:cNvCxnSpPr>
          <p:nvPr/>
        </p:nvCxnSpPr>
        <p:spPr>
          <a:xfrm flipV="1">
            <a:off x="7468183" y="3328066"/>
            <a:ext cx="491798" cy="82971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36041008-A38C-04EB-1D94-B58F105FE40C}"/>
              </a:ext>
            </a:extLst>
          </p:cNvPr>
          <p:cNvCxnSpPr>
            <a:cxnSpLocks/>
          </p:cNvCxnSpPr>
          <p:nvPr/>
        </p:nvCxnSpPr>
        <p:spPr>
          <a:xfrm>
            <a:off x="7959981" y="3325914"/>
            <a:ext cx="468000" cy="0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4EFC2A42-2204-CBA0-7063-647B66327192}"/>
              </a:ext>
            </a:extLst>
          </p:cNvPr>
          <p:cNvCxnSpPr>
            <a:cxnSpLocks/>
          </p:cNvCxnSpPr>
          <p:nvPr/>
        </p:nvCxnSpPr>
        <p:spPr>
          <a:xfrm flipV="1">
            <a:off x="8410998" y="3230136"/>
            <a:ext cx="486753" cy="95783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E804210D-E89E-5847-C141-896FC1687C28}"/>
              </a:ext>
            </a:extLst>
          </p:cNvPr>
          <p:cNvCxnSpPr>
            <a:cxnSpLocks/>
          </p:cNvCxnSpPr>
          <p:nvPr/>
        </p:nvCxnSpPr>
        <p:spPr>
          <a:xfrm flipV="1">
            <a:off x="8905206" y="3194985"/>
            <a:ext cx="452423" cy="35151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A6C208EA-CA1A-4589-7BF7-3DEEE58E9552}"/>
              </a:ext>
            </a:extLst>
          </p:cNvPr>
          <p:cNvCxnSpPr>
            <a:cxnSpLocks/>
          </p:cNvCxnSpPr>
          <p:nvPr/>
        </p:nvCxnSpPr>
        <p:spPr>
          <a:xfrm flipV="1">
            <a:off x="9375244" y="3096144"/>
            <a:ext cx="515843" cy="98841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57AC52DB-6859-300C-7567-12DF60C07698}"/>
              </a:ext>
            </a:extLst>
          </p:cNvPr>
          <p:cNvCxnSpPr>
            <a:cxnSpLocks/>
          </p:cNvCxnSpPr>
          <p:nvPr/>
        </p:nvCxnSpPr>
        <p:spPr>
          <a:xfrm>
            <a:off x="9846736" y="3097391"/>
            <a:ext cx="468000" cy="97594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7CE6A145-BD69-CCB4-20BB-95AF70AFAA3D}"/>
              </a:ext>
            </a:extLst>
          </p:cNvPr>
          <p:cNvSpPr txBox="1"/>
          <p:nvPr/>
        </p:nvSpPr>
        <p:spPr>
          <a:xfrm>
            <a:off x="7597057" y="215909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84115C3-FFDC-55CA-1AEB-A1AB3F52BFD4}"/>
              </a:ext>
            </a:extLst>
          </p:cNvPr>
          <p:cNvSpPr txBox="1"/>
          <p:nvPr/>
        </p:nvSpPr>
        <p:spPr>
          <a:xfrm>
            <a:off x="8075499" y="2161244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1AEA3128-BB3B-6A9E-57D3-BA56CBB3D1BD}"/>
              </a:ext>
            </a:extLst>
          </p:cNvPr>
          <p:cNvSpPr txBox="1"/>
          <p:nvPr/>
        </p:nvSpPr>
        <p:spPr>
          <a:xfrm>
            <a:off x="8548026" y="1586456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A68EFA2E-ECC3-948B-67B7-A5ABBA8CF268}"/>
              </a:ext>
            </a:extLst>
          </p:cNvPr>
          <p:cNvSpPr txBox="1"/>
          <p:nvPr/>
        </p:nvSpPr>
        <p:spPr>
          <a:xfrm>
            <a:off x="9022895" y="1597372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96A286FA-5F45-789F-0E8A-3E8D32438D98}"/>
              </a:ext>
            </a:extLst>
          </p:cNvPr>
          <p:cNvSpPr txBox="1"/>
          <p:nvPr/>
        </p:nvSpPr>
        <p:spPr>
          <a:xfrm>
            <a:off x="9509626" y="593558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5C4A61D-5C31-401F-530B-EA9AFEC886D5}"/>
              </a:ext>
            </a:extLst>
          </p:cNvPr>
          <p:cNvSpPr txBox="1"/>
          <p:nvPr/>
        </p:nvSpPr>
        <p:spPr>
          <a:xfrm>
            <a:off x="9980838" y="670926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101DA0C-3DFE-3357-98BB-69DE0332B7EC}"/>
              </a:ext>
            </a:extLst>
          </p:cNvPr>
          <p:cNvSpPr txBox="1"/>
          <p:nvPr/>
        </p:nvSpPr>
        <p:spPr>
          <a:xfrm rot="16200000">
            <a:off x="6057378" y="1958059"/>
            <a:ext cx="1008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LLS (points)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262587AA-99A3-4C2C-5AFA-1EB220CAEC85}"/>
              </a:ext>
            </a:extLst>
          </p:cNvPr>
          <p:cNvSpPr txBox="1"/>
          <p:nvPr/>
        </p:nvSpPr>
        <p:spPr>
          <a:xfrm>
            <a:off x="6190686" y="5044569"/>
            <a:ext cx="405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+mj-lt"/>
              </a:rPr>
              <a:t>E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4C4D5E13-1840-A802-E274-0D68C0CECC2E}"/>
              </a:ext>
            </a:extLst>
          </p:cNvPr>
          <p:cNvSpPr txBox="1"/>
          <p:nvPr/>
        </p:nvSpPr>
        <p:spPr>
          <a:xfrm>
            <a:off x="8491183" y="8136112"/>
            <a:ext cx="609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Hours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BC7BADF1-79E0-D3E6-AC1F-D6468F9A67B2}"/>
              </a:ext>
            </a:extLst>
          </p:cNvPr>
          <p:cNvSpPr txBox="1"/>
          <p:nvPr/>
        </p:nvSpPr>
        <p:spPr>
          <a:xfrm>
            <a:off x="7086593" y="5162760"/>
            <a:ext cx="1679883" cy="520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State: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Time: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State × Time: P = &lt;0.001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57DFC8D-E9C0-0322-9922-82D71B4CBD9F}"/>
              </a:ext>
            </a:extLst>
          </p:cNvPr>
          <p:cNvSpPr txBox="1"/>
          <p:nvPr/>
        </p:nvSpPr>
        <p:spPr>
          <a:xfrm>
            <a:off x="8067249" y="7031206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54451290-C140-A040-BFD3-4AC39328A9CB}"/>
              </a:ext>
            </a:extLst>
          </p:cNvPr>
          <p:cNvSpPr txBox="1"/>
          <p:nvPr/>
        </p:nvSpPr>
        <p:spPr>
          <a:xfrm>
            <a:off x="8537936" y="6477463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617EDEC4-CB90-42D3-913C-0ABB0BDDCE4A}"/>
              </a:ext>
            </a:extLst>
          </p:cNvPr>
          <p:cNvSpPr txBox="1"/>
          <p:nvPr/>
        </p:nvSpPr>
        <p:spPr>
          <a:xfrm rot="16200000">
            <a:off x="6095170" y="6294693"/>
            <a:ext cx="981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ESQ-C (AU)</a:t>
            </a:r>
          </a:p>
        </p:txBody>
      </p:sp>
      <p:pic>
        <p:nvPicPr>
          <p:cNvPr id="167" name="Picture 166">
            <a:extLst>
              <a:ext uri="{FF2B5EF4-FFF2-40B4-BE49-F238E27FC236}">
                <a16:creationId xmlns:a16="http://schemas.microsoft.com/office/drawing/2014/main" id="{22A5703E-B2C6-44E0-6EAB-966C6A7E2DC8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6709971" y="5126208"/>
            <a:ext cx="3848100" cy="3009900"/>
          </a:xfrm>
          <a:prstGeom prst="rect">
            <a:avLst/>
          </a:prstGeom>
        </p:spPr>
      </p:pic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E3263F81-F731-436B-0976-0D26C0A184DF}"/>
              </a:ext>
            </a:extLst>
          </p:cNvPr>
          <p:cNvCxnSpPr>
            <a:cxnSpLocks/>
          </p:cNvCxnSpPr>
          <p:nvPr/>
        </p:nvCxnSpPr>
        <p:spPr>
          <a:xfrm flipV="1">
            <a:off x="7256398" y="7433210"/>
            <a:ext cx="486513" cy="261667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AC7378C1-058B-9BBB-E41D-9A02B83B90BB}"/>
              </a:ext>
            </a:extLst>
          </p:cNvPr>
          <p:cNvCxnSpPr>
            <a:cxnSpLocks/>
          </p:cNvCxnSpPr>
          <p:nvPr/>
        </p:nvCxnSpPr>
        <p:spPr>
          <a:xfrm>
            <a:off x="7725986" y="7434468"/>
            <a:ext cx="495367" cy="74569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D4D70934-0F57-6A98-EC86-CD025CDC8D8D}"/>
              </a:ext>
            </a:extLst>
          </p:cNvPr>
          <p:cNvCxnSpPr>
            <a:cxnSpLocks/>
          </p:cNvCxnSpPr>
          <p:nvPr/>
        </p:nvCxnSpPr>
        <p:spPr>
          <a:xfrm flipV="1">
            <a:off x="8210912" y="7318226"/>
            <a:ext cx="480029" cy="190811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D912B624-5ABC-54F4-ADD6-AB17210639C0}"/>
              </a:ext>
            </a:extLst>
          </p:cNvPr>
          <p:cNvCxnSpPr>
            <a:cxnSpLocks/>
          </p:cNvCxnSpPr>
          <p:nvPr/>
        </p:nvCxnSpPr>
        <p:spPr>
          <a:xfrm>
            <a:off x="7472274" y="7722247"/>
            <a:ext cx="468000" cy="0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DFB0D735-E0AB-3255-E5C8-0B4A21FC6AE7}"/>
              </a:ext>
            </a:extLst>
          </p:cNvPr>
          <p:cNvCxnSpPr>
            <a:cxnSpLocks/>
          </p:cNvCxnSpPr>
          <p:nvPr/>
        </p:nvCxnSpPr>
        <p:spPr>
          <a:xfrm flipV="1">
            <a:off x="8690941" y="7130366"/>
            <a:ext cx="480029" cy="190811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672C0C39-8998-71CB-CFED-4A7A44DC89AE}"/>
              </a:ext>
            </a:extLst>
          </p:cNvPr>
          <p:cNvCxnSpPr>
            <a:cxnSpLocks/>
          </p:cNvCxnSpPr>
          <p:nvPr/>
        </p:nvCxnSpPr>
        <p:spPr>
          <a:xfrm flipV="1">
            <a:off x="9177318" y="6642759"/>
            <a:ext cx="455847" cy="477758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887F5E4C-5892-FE28-1ECC-169BFA103733}"/>
              </a:ext>
            </a:extLst>
          </p:cNvPr>
          <p:cNvCxnSpPr>
            <a:cxnSpLocks/>
          </p:cNvCxnSpPr>
          <p:nvPr/>
        </p:nvCxnSpPr>
        <p:spPr>
          <a:xfrm flipV="1">
            <a:off x="9633165" y="6513809"/>
            <a:ext cx="493527" cy="128955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F370FBD9-A6B8-68AD-45F5-B87B208B4CCC}"/>
              </a:ext>
            </a:extLst>
          </p:cNvPr>
          <p:cNvCxnSpPr>
            <a:cxnSpLocks/>
          </p:cNvCxnSpPr>
          <p:nvPr/>
        </p:nvCxnSpPr>
        <p:spPr>
          <a:xfrm>
            <a:off x="8003921" y="7722247"/>
            <a:ext cx="468000" cy="0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8517F079-D12B-092E-D334-925DD029A053}"/>
              </a:ext>
            </a:extLst>
          </p:cNvPr>
          <p:cNvCxnSpPr>
            <a:cxnSpLocks/>
          </p:cNvCxnSpPr>
          <p:nvPr/>
        </p:nvCxnSpPr>
        <p:spPr>
          <a:xfrm flipV="1">
            <a:off x="8456936" y="7694872"/>
            <a:ext cx="440810" cy="19830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22DFD5F3-20D2-28BF-B9BD-C24D951F3919}"/>
              </a:ext>
            </a:extLst>
          </p:cNvPr>
          <p:cNvCxnSpPr>
            <a:cxnSpLocks/>
          </p:cNvCxnSpPr>
          <p:nvPr/>
        </p:nvCxnSpPr>
        <p:spPr>
          <a:xfrm flipV="1">
            <a:off x="8939698" y="7671822"/>
            <a:ext cx="440810" cy="19830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28CBAFA6-57EC-DF49-F53A-A0AD0F01DFEF}"/>
              </a:ext>
            </a:extLst>
          </p:cNvPr>
          <p:cNvCxnSpPr>
            <a:cxnSpLocks/>
          </p:cNvCxnSpPr>
          <p:nvPr/>
        </p:nvCxnSpPr>
        <p:spPr>
          <a:xfrm flipV="1">
            <a:off x="9449320" y="7618402"/>
            <a:ext cx="397416" cy="73255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8B3ED21F-E650-C338-6922-4CB53465EF65}"/>
              </a:ext>
            </a:extLst>
          </p:cNvPr>
          <p:cNvCxnSpPr>
            <a:cxnSpLocks/>
          </p:cNvCxnSpPr>
          <p:nvPr/>
        </p:nvCxnSpPr>
        <p:spPr>
          <a:xfrm>
            <a:off x="9874626" y="7616423"/>
            <a:ext cx="440110" cy="1979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8" name="TextBox 187">
            <a:extLst>
              <a:ext uri="{FF2B5EF4-FFF2-40B4-BE49-F238E27FC236}">
                <a16:creationId xmlns:a16="http://schemas.microsoft.com/office/drawing/2014/main" id="{CC5EF9A2-DE6D-8FA1-5146-582DB80BF043}"/>
              </a:ext>
            </a:extLst>
          </p:cNvPr>
          <p:cNvSpPr txBox="1"/>
          <p:nvPr/>
        </p:nvSpPr>
        <p:spPr>
          <a:xfrm>
            <a:off x="7591051" y="6851360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D37E769B-3DBF-1B5E-CB37-A0175086E7E3}"/>
              </a:ext>
            </a:extLst>
          </p:cNvPr>
          <p:cNvSpPr txBox="1"/>
          <p:nvPr/>
        </p:nvSpPr>
        <p:spPr>
          <a:xfrm>
            <a:off x="9016785" y="6470193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1B84250E-E1E7-01B1-2384-5503D67A2A23}"/>
              </a:ext>
            </a:extLst>
          </p:cNvPr>
          <p:cNvSpPr txBox="1"/>
          <p:nvPr/>
        </p:nvSpPr>
        <p:spPr>
          <a:xfrm>
            <a:off x="9487310" y="5543656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1F34975C-A89D-22AF-7E7C-279B180066ED}"/>
              </a:ext>
            </a:extLst>
          </p:cNvPr>
          <p:cNvSpPr txBox="1"/>
          <p:nvPr/>
        </p:nvSpPr>
        <p:spPr>
          <a:xfrm>
            <a:off x="9966190" y="5441919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625DFE92-BA6C-2E31-C939-8FF95617E979}"/>
              </a:ext>
            </a:extLst>
          </p:cNvPr>
          <p:cNvSpPr txBox="1"/>
          <p:nvPr/>
        </p:nvSpPr>
        <p:spPr>
          <a:xfrm>
            <a:off x="6213769" y="9350621"/>
            <a:ext cx="39305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+mj-lt"/>
              </a:rPr>
              <a:t>F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CD1FFDE-C27C-F498-433B-C06445FDE928}"/>
              </a:ext>
            </a:extLst>
          </p:cNvPr>
          <p:cNvSpPr txBox="1"/>
          <p:nvPr/>
        </p:nvSpPr>
        <p:spPr>
          <a:xfrm>
            <a:off x="8524433" y="12443870"/>
            <a:ext cx="609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Hours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A98FA406-4F1E-5C0C-1555-1A9E21AD3DC5}"/>
              </a:ext>
            </a:extLst>
          </p:cNvPr>
          <p:cNvSpPr txBox="1"/>
          <p:nvPr/>
        </p:nvSpPr>
        <p:spPr>
          <a:xfrm>
            <a:off x="7119202" y="9491615"/>
            <a:ext cx="1679883" cy="520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State: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Time: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State × Time: P = &lt;0.001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76E60F84-ED6B-B699-FDAA-5B10D401D406}"/>
              </a:ext>
            </a:extLst>
          </p:cNvPr>
          <p:cNvSpPr txBox="1"/>
          <p:nvPr/>
        </p:nvSpPr>
        <p:spPr>
          <a:xfrm rot="16200000">
            <a:off x="6173627" y="10623548"/>
            <a:ext cx="890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VAS (mm)</a:t>
            </a:r>
          </a:p>
        </p:txBody>
      </p:sp>
      <p:pic>
        <p:nvPicPr>
          <p:cNvPr id="220" name="Picture 219">
            <a:extLst>
              <a:ext uri="{FF2B5EF4-FFF2-40B4-BE49-F238E27FC236}">
                <a16:creationId xmlns:a16="http://schemas.microsoft.com/office/drawing/2014/main" id="{65BBF4D6-415C-3CD7-5CF1-797A56B03CA9}"/>
              </a:ext>
            </a:extLst>
          </p:cNvPr>
          <p:cNvPicPr>
            <a:picLocks noChangeAspect="1"/>
          </p:cNvPicPr>
          <p:nvPr/>
        </p:nvPicPr>
        <p:blipFill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6765633" y="9435941"/>
            <a:ext cx="3848100" cy="3028950"/>
          </a:xfrm>
          <a:prstGeom prst="rect">
            <a:avLst/>
          </a:prstGeom>
        </p:spPr>
      </p:pic>
      <p:sp>
        <p:nvSpPr>
          <p:cNvPr id="221" name="TextBox 220">
            <a:extLst>
              <a:ext uri="{FF2B5EF4-FFF2-40B4-BE49-F238E27FC236}">
                <a16:creationId xmlns:a16="http://schemas.microsoft.com/office/drawing/2014/main" id="{93A2AA09-1659-4B26-8199-9E994566CFC6}"/>
              </a:ext>
            </a:extLst>
          </p:cNvPr>
          <p:cNvSpPr txBox="1"/>
          <p:nvPr/>
        </p:nvSpPr>
        <p:spPr>
          <a:xfrm>
            <a:off x="7616507" y="9963043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59DB5B67-B628-8894-787D-6FC9F0ACFF12}"/>
              </a:ext>
            </a:extLst>
          </p:cNvPr>
          <p:cNvSpPr txBox="1"/>
          <p:nvPr/>
        </p:nvSpPr>
        <p:spPr>
          <a:xfrm>
            <a:off x="8098406" y="10676460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cxnSp>
        <p:nvCxnSpPr>
          <p:cNvPr id="223" name="Straight Connector 222">
            <a:extLst>
              <a:ext uri="{FF2B5EF4-FFF2-40B4-BE49-F238E27FC236}">
                <a16:creationId xmlns:a16="http://schemas.microsoft.com/office/drawing/2014/main" id="{1F83BAE6-F678-5473-682C-251F7BC29DD3}"/>
              </a:ext>
            </a:extLst>
          </p:cNvPr>
          <p:cNvCxnSpPr>
            <a:cxnSpLocks/>
          </p:cNvCxnSpPr>
          <p:nvPr/>
        </p:nvCxnSpPr>
        <p:spPr>
          <a:xfrm flipV="1">
            <a:off x="7301101" y="11404886"/>
            <a:ext cx="482138" cy="573578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5" name="TextBox 234">
            <a:extLst>
              <a:ext uri="{FF2B5EF4-FFF2-40B4-BE49-F238E27FC236}">
                <a16:creationId xmlns:a16="http://schemas.microsoft.com/office/drawing/2014/main" id="{A4E166E9-C860-DEAE-339F-F329D1C0821B}"/>
              </a:ext>
            </a:extLst>
          </p:cNvPr>
          <p:cNvSpPr txBox="1"/>
          <p:nvPr/>
        </p:nvSpPr>
        <p:spPr>
          <a:xfrm>
            <a:off x="7148853" y="11542382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60E4E428-3B63-E7D1-38A0-39186E3192F8}"/>
              </a:ext>
            </a:extLst>
          </p:cNvPr>
          <p:cNvSpPr txBox="1"/>
          <p:nvPr/>
        </p:nvSpPr>
        <p:spPr>
          <a:xfrm>
            <a:off x="8569327" y="10323161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020B89DA-FE34-7ECC-D0C4-00F687EB0818}"/>
              </a:ext>
            </a:extLst>
          </p:cNvPr>
          <p:cNvCxnSpPr>
            <a:cxnSpLocks/>
          </p:cNvCxnSpPr>
          <p:nvPr/>
        </p:nvCxnSpPr>
        <p:spPr>
          <a:xfrm>
            <a:off x="7772076" y="11404890"/>
            <a:ext cx="465849" cy="117787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053750E7-EAB4-3C42-3C5B-B1AAE3C9262F}"/>
              </a:ext>
            </a:extLst>
          </p:cNvPr>
          <p:cNvCxnSpPr>
            <a:cxnSpLocks/>
          </p:cNvCxnSpPr>
          <p:nvPr/>
        </p:nvCxnSpPr>
        <p:spPr>
          <a:xfrm flipV="1">
            <a:off x="8239000" y="11404890"/>
            <a:ext cx="483851" cy="113601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7" name="Straight Connector 246">
            <a:extLst>
              <a:ext uri="{FF2B5EF4-FFF2-40B4-BE49-F238E27FC236}">
                <a16:creationId xmlns:a16="http://schemas.microsoft.com/office/drawing/2014/main" id="{6F8198AA-4BD5-C0AC-CF6E-714825AE5BFE}"/>
              </a:ext>
            </a:extLst>
          </p:cNvPr>
          <p:cNvCxnSpPr>
            <a:cxnSpLocks/>
          </p:cNvCxnSpPr>
          <p:nvPr/>
        </p:nvCxnSpPr>
        <p:spPr>
          <a:xfrm flipV="1">
            <a:off x="8723720" y="11338011"/>
            <a:ext cx="460185" cy="66879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Connector 248">
            <a:extLst>
              <a:ext uri="{FF2B5EF4-FFF2-40B4-BE49-F238E27FC236}">
                <a16:creationId xmlns:a16="http://schemas.microsoft.com/office/drawing/2014/main" id="{80B8E395-3A64-F5AD-9349-E79DD3E468F3}"/>
              </a:ext>
            </a:extLst>
          </p:cNvPr>
          <p:cNvCxnSpPr>
            <a:cxnSpLocks/>
          </p:cNvCxnSpPr>
          <p:nvPr/>
        </p:nvCxnSpPr>
        <p:spPr>
          <a:xfrm flipV="1">
            <a:off x="9167225" y="10700417"/>
            <a:ext cx="501503" cy="635304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B77DD726-2598-0B40-250B-8225AC8E4DBC}"/>
              </a:ext>
            </a:extLst>
          </p:cNvPr>
          <p:cNvCxnSpPr>
            <a:cxnSpLocks/>
          </p:cNvCxnSpPr>
          <p:nvPr/>
        </p:nvCxnSpPr>
        <p:spPr>
          <a:xfrm flipV="1">
            <a:off x="9670190" y="10253487"/>
            <a:ext cx="497359" cy="446771"/>
          </a:xfrm>
          <a:prstGeom prst="line">
            <a:avLst/>
          </a:prstGeom>
          <a:ln w="6350"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Connector 253">
            <a:extLst>
              <a:ext uri="{FF2B5EF4-FFF2-40B4-BE49-F238E27FC236}">
                <a16:creationId xmlns:a16="http://schemas.microsoft.com/office/drawing/2014/main" id="{2CC1A803-810A-6A9A-FE6C-7C54D1FD4F87}"/>
              </a:ext>
            </a:extLst>
          </p:cNvPr>
          <p:cNvCxnSpPr>
            <a:cxnSpLocks/>
          </p:cNvCxnSpPr>
          <p:nvPr/>
        </p:nvCxnSpPr>
        <p:spPr>
          <a:xfrm>
            <a:off x="7480082" y="12054971"/>
            <a:ext cx="468000" cy="0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5" name="Straight Connector 254">
            <a:extLst>
              <a:ext uri="{FF2B5EF4-FFF2-40B4-BE49-F238E27FC236}">
                <a16:creationId xmlns:a16="http://schemas.microsoft.com/office/drawing/2014/main" id="{3B106EBB-5AF5-D1B7-2A7D-00EBD94B4EDE}"/>
              </a:ext>
            </a:extLst>
          </p:cNvPr>
          <p:cNvCxnSpPr>
            <a:cxnSpLocks/>
          </p:cNvCxnSpPr>
          <p:nvPr/>
        </p:nvCxnSpPr>
        <p:spPr>
          <a:xfrm flipV="1">
            <a:off x="7973669" y="11978468"/>
            <a:ext cx="477257" cy="76507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7" name="Straight Connector 256">
            <a:extLst>
              <a:ext uri="{FF2B5EF4-FFF2-40B4-BE49-F238E27FC236}">
                <a16:creationId xmlns:a16="http://schemas.microsoft.com/office/drawing/2014/main" id="{12CC9257-8626-C29A-E07D-FAB33C774E5D}"/>
              </a:ext>
            </a:extLst>
          </p:cNvPr>
          <p:cNvCxnSpPr>
            <a:cxnSpLocks/>
          </p:cNvCxnSpPr>
          <p:nvPr/>
        </p:nvCxnSpPr>
        <p:spPr>
          <a:xfrm flipV="1">
            <a:off x="8462445" y="11867348"/>
            <a:ext cx="464549" cy="95285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9" name="Straight Connector 258">
            <a:extLst>
              <a:ext uri="{FF2B5EF4-FFF2-40B4-BE49-F238E27FC236}">
                <a16:creationId xmlns:a16="http://schemas.microsoft.com/office/drawing/2014/main" id="{74AD9EA5-99A9-F8A8-B89A-CF96F26CA582}"/>
              </a:ext>
            </a:extLst>
          </p:cNvPr>
          <p:cNvCxnSpPr>
            <a:cxnSpLocks/>
          </p:cNvCxnSpPr>
          <p:nvPr/>
        </p:nvCxnSpPr>
        <p:spPr>
          <a:xfrm>
            <a:off x="8909804" y="11867344"/>
            <a:ext cx="495437" cy="47642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1" name="Straight Connector 260">
            <a:extLst>
              <a:ext uri="{FF2B5EF4-FFF2-40B4-BE49-F238E27FC236}">
                <a16:creationId xmlns:a16="http://schemas.microsoft.com/office/drawing/2014/main" id="{30E5C83A-7FED-BDD0-00BE-AABDB7848DDC}"/>
              </a:ext>
            </a:extLst>
          </p:cNvPr>
          <p:cNvCxnSpPr>
            <a:cxnSpLocks/>
          </p:cNvCxnSpPr>
          <p:nvPr/>
        </p:nvCxnSpPr>
        <p:spPr>
          <a:xfrm flipV="1">
            <a:off x="9399773" y="11822987"/>
            <a:ext cx="491313" cy="97657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3" name="Straight Connector 262">
            <a:extLst>
              <a:ext uri="{FF2B5EF4-FFF2-40B4-BE49-F238E27FC236}">
                <a16:creationId xmlns:a16="http://schemas.microsoft.com/office/drawing/2014/main" id="{A50D81DD-3453-9D6E-D070-854ECABF346B}"/>
              </a:ext>
            </a:extLst>
          </p:cNvPr>
          <p:cNvCxnSpPr>
            <a:cxnSpLocks/>
          </p:cNvCxnSpPr>
          <p:nvPr/>
        </p:nvCxnSpPr>
        <p:spPr>
          <a:xfrm>
            <a:off x="9911170" y="11813791"/>
            <a:ext cx="470852" cy="101199"/>
          </a:xfrm>
          <a:prstGeom prst="line">
            <a:avLst/>
          </a:prstGeom>
          <a:ln w="6350">
            <a:solidFill>
              <a:schemeClr val="accent2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5" name="TextBox 264">
            <a:extLst>
              <a:ext uri="{FF2B5EF4-FFF2-40B4-BE49-F238E27FC236}">
                <a16:creationId xmlns:a16="http://schemas.microsoft.com/office/drawing/2014/main" id="{5C89192F-C04E-67E4-D816-005F59854883}"/>
              </a:ext>
            </a:extLst>
          </p:cNvPr>
          <p:cNvSpPr txBox="1"/>
          <p:nvPr/>
        </p:nvSpPr>
        <p:spPr>
          <a:xfrm>
            <a:off x="9050572" y="10676460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8D28E705-2DDD-8D2E-7464-D036EEDBEA00}"/>
              </a:ext>
            </a:extLst>
          </p:cNvPr>
          <p:cNvSpPr txBox="1"/>
          <p:nvPr/>
        </p:nvSpPr>
        <p:spPr>
          <a:xfrm>
            <a:off x="9522873" y="961826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2996893B-D1DF-8FAF-309C-F0CEA9A03FCB}"/>
              </a:ext>
            </a:extLst>
          </p:cNvPr>
          <p:cNvSpPr txBox="1"/>
          <p:nvPr/>
        </p:nvSpPr>
        <p:spPr>
          <a:xfrm>
            <a:off x="10000745" y="9444115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9457C7-C55C-E219-20BC-510A8AD07A8B}"/>
              </a:ext>
            </a:extLst>
          </p:cNvPr>
          <p:cNvSpPr txBox="1"/>
          <p:nvPr/>
        </p:nvSpPr>
        <p:spPr>
          <a:xfrm>
            <a:off x="212924" y="789103"/>
            <a:ext cx="4235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+mj-lt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7EC9E4-037F-F139-8E10-6E707AE29D5E}"/>
              </a:ext>
            </a:extLst>
          </p:cNvPr>
          <p:cNvSpPr txBox="1"/>
          <p:nvPr/>
        </p:nvSpPr>
        <p:spPr>
          <a:xfrm>
            <a:off x="2580485" y="3832241"/>
            <a:ext cx="609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Hour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2AF6856-7EEF-5B7D-07D3-67A3D469851C}"/>
              </a:ext>
            </a:extLst>
          </p:cNvPr>
          <p:cNvSpPr txBox="1"/>
          <p:nvPr/>
        </p:nvSpPr>
        <p:spPr>
          <a:xfrm>
            <a:off x="1107461" y="929644"/>
            <a:ext cx="1967205" cy="520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Condition: P = 0.004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Time:        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Condition × Time: P = &lt;0.001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D56B5EE-D26D-B2D8-AE9D-46A29C33BB60}"/>
              </a:ext>
            </a:extLst>
          </p:cNvPr>
          <p:cNvCxnSpPr>
            <a:cxnSpLocks/>
          </p:cNvCxnSpPr>
          <p:nvPr/>
        </p:nvCxnSpPr>
        <p:spPr>
          <a:xfrm flipV="1">
            <a:off x="1500796" y="3060726"/>
            <a:ext cx="483710" cy="36938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19E5D33-05AA-368F-6D7D-8F55801B112E}"/>
              </a:ext>
            </a:extLst>
          </p:cNvPr>
          <p:cNvCxnSpPr>
            <a:cxnSpLocks/>
          </p:cNvCxnSpPr>
          <p:nvPr/>
        </p:nvCxnSpPr>
        <p:spPr>
          <a:xfrm>
            <a:off x="2028244" y="3060726"/>
            <a:ext cx="468000" cy="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0D38E49-08A5-6364-1D5E-3AA8C140D0C6}"/>
              </a:ext>
            </a:extLst>
          </p:cNvPr>
          <p:cNvCxnSpPr>
            <a:cxnSpLocks/>
          </p:cNvCxnSpPr>
          <p:nvPr/>
        </p:nvCxnSpPr>
        <p:spPr>
          <a:xfrm flipV="1">
            <a:off x="2456319" y="2799569"/>
            <a:ext cx="486751" cy="250192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85994AC-7571-ECDF-1019-3AE4FEDD2BCE}"/>
              </a:ext>
            </a:extLst>
          </p:cNvPr>
          <p:cNvCxnSpPr>
            <a:cxnSpLocks/>
          </p:cNvCxnSpPr>
          <p:nvPr/>
        </p:nvCxnSpPr>
        <p:spPr>
          <a:xfrm>
            <a:off x="2921372" y="2808726"/>
            <a:ext cx="499190" cy="12558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4FFB627-A092-B5A6-3371-47BAEAC0FD33}"/>
              </a:ext>
            </a:extLst>
          </p:cNvPr>
          <p:cNvCxnSpPr>
            <a:cxnSpLocks/>
          </p:cNvCxnSpPr>
          <p:nvPr/>
        </p:nvCxnSpPr>
        <p:spPr>
          <a:xfrm flipV="1">
            <a:off x="3420562" y="2511235"/>
            <a:ext cx="485404" cy="30377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7DD5B8D-C01D-0BFF-5BA1-8A146646BCE6}"/>
              </a:ext>
            </a:extLst>
          </p:cNvPr>
          <p:cNvCxnSpPr>
            <a:cxnSpLocks/>
          </p:cNvCxnSpPr>
          <p:nvPr/>
        </p:nvCxnSpPr>
        <p:spPr>
          <a:xfrm flipV="1">
            <a:off x="3891567" y="2401846"/>
            <a:ext cx="492174" cy="114121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D81BE11-1CD5-7B0C-2443-48BBCDD13AA3}"/>
              </a:ext>
            </a:extLst>
          </p:cNvPr>
          <p:cNvCxnSpPr>
            <a:cxnSpLocks/>
          </p:cNvCxnSpPr>
          <p:nvPr/>
        </p:nvCxnSpPr>
        <p:spPr>
          <a:xfrm flipV="1">
            <a:off x="1329904" y="3346820"/>
            <a:ext cx="441403" cy="83286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04B89DA-393E-CE1F-CD65-F6B6717C8B3A}"/>
              </a:ext>
            </a:extLst>
          </p:cNvPr>
          <p:cNvCxnSpPr>
            <a:cxnSpLocks/>
          </p:cNvCxnSpPr>
          <p:nvPr/>
        </p:nvCxnSpPr>
        <p:spPr>
          <a:xfrm>
            <a:off x="1807679" y="3346820"/>
            <a:ext cx="468000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E2D0CC7-5FA4-9232-7644-D8046E0F49AF}"/>
              </a:ext>
            </a:extLst>
          </p:cNvPr>
          <p:cNvCxnSpPr>
            <a:cxnSpLocks/>
          </p:cNvCxnSpPr>
          <p:nvPr/>
        </p:nvCxnSpPr>
        <p:spPr>
          <a:xfrm flipV="1">
            <a:off x="2273749" y="3313053"/>
            <a:ext cx="462513" cy="52322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E87C3C2-A505-7838-9F2F-A5AD783D555F}"/>
              </a:ext>
            </a:extLst>
          </p:cNvPr>
          <p:cNvCxnSpPr>
            <a:cxnSpLocks/>
          </p:cNvCxnSpPr>
          <p:nvPr/>
        </p:nvCxnSpPr>
        <p:spPr>
          <a:xfrm>
            <a:off x="2789321" y="3317469"/>
            <a:ext cx="439902" cy="15863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472D989-87DE-FCD7-D0BE-80A3E549DEA1}"/>
              </a:ext>
            </a:extLst>
          </p:cNvPr>
          <p:cNvCxnSpPr>
            <a:cxnSpLocks/>
          </p:cNvCxnSpPr>
          <p:nvPr/>
        </p:nvCxnSpPr>
        <p:spPr>
          <a:xfrm flipV="1">
            <a:off x="3264608" y="3309356"/>
            <a:ext cx="436193" cy="2187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4DCD4AA-BF8E-B67D-8C1D-4B57CF53742C}"/>
              </a:ext>
            </a:extLst>
          </p:cNvPr>
          <p:cNvCxnSpPr>
            <a:cxnSpLocks/>
          </p:cNvCxnSpPr>
          <p:nvPr/>
        </p:nvCxnSpPr>
        <p:spPr>
          <a:xfrm>
            <a:off x="3714048" y="3309353"/>
            <a:ext cx="443317" cy="16044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6BB5AE7-3268-CFB0-4274-AC52BE0B2E4B}"/>
              </a:ext>
            </a:extLst>
          </p:cNvPr>
          <p:cNvSpPr txBox="1"/>
          <p:nvPr/>
        </p:nvSpPr>
        <p:spPr>
          <a:xfrm>
            <a:off x="1844424" y="219233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929A569-4FAA-ED0C-FCF6-0CF263F524A0}"/>
              </a:ext>
            </a:extLst>
          </p:cNvPr>
          <p:cNvSpPr txBox="1"/>
          <p:nvPr/>
        </p:nvSpPr>
        <p:spPr>
          <a:xfrm>
            <a:off x="2310651" y="2188579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BB894E0-E571-FF88-5670-64A49C5A81BB}"/>
              </a:ext>
            </a:extLst>
          </p:cNvPr>
          <p:cNvSpPr txBox="1"/>
          <p:nvPr/>
        </p:nvSpPr>
        <p:spPr>
          <a:xfrm>
            <a:off x="2794957" y="1570293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70DF319-DEF4-7841-8F6C-FF3EB06D19AE}"/>
              </a:ext>
            </a:extLst>
          </p:cNvPr>
          <p:cNvSpPr txBox="1"/>
          <p:nvPr/>
        </p:nvSpPr>
        <p:spPr>
          <a:xfrm>
            <a:off x="3281686" y="1576864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157CAA5-F582-57CF-C4EA-064EBCD4FC70}"/>
              </a:ext>
            </a:extLst>
          </p:cNvPr>
          <p:cNvSpPr txBox="1"/>
          <p:nvPr/>
        </p:nvSpPr>
        <p:spPr>
          <a:xfrm>
            <a:off x="3755832" y="64750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4D59A7D-F717-8EC6-806F-CECB9B84531C}"/>
              </a:ext>
            </a:extLst>
          </p:cNvPr>
          <p:cNvSpPr txBox="1"/>
          <p:nvPr/>
        </p:nvSpPr>
        <p:spPr>
          <a:xfrm>
            <a:off x="4239029" y="64750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8B90129-58AF-BB5A-8EFB-69E43DB470F5}"/>
              </a:ext>
            </a:extLst>
          </p:cNvPr>
          <p:cNvSpPr txBox="1"/>
          <p:nvPr/>
        </p:nvSpPr>
        <p:spPr>
          <a:xfrm rot="16200000">
            <a:off x="102697" y="1958059"/>
            <a:ext cx="1008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LLS (points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CAFBCD9-656A-92D3-CC52-F8EA841D3D61}"/>
              </a:ext>
            </a:extLst>
          </p:cNvPr>
          <p:cNvSpPr txBox="1"/>
          <p:nvPr/>
        </p:nvSpPr>
        <p:spPr>
          <a:xfrm>
            <a:off x="236007" y="5044569"/>
            <a:ext cx="4235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+mj-lt"/>
              </a:rPr>
              <a:t>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0FB761E-9D9C-5EDB-E7A7-087D3FF6E4BD}"/>
              </a:ext>
            </a:extLst>
          </p:cNvPr>
          <p:cNvSpPr txBox="1"/>
          <p:nvPr/>
        </p:nvSpPr>
        <p:spPr>
          <a:xfrm>
            <a:off x="2536504" y="8136112"/>
            <a:ext cx="609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Hour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1119880-8A42-0542-0952-C8165CA8B7C0}"/>
              </a:ext>
            </a:extLst>
          </p:cNvPr>
          <p:cNvSpPr txBox="1"/>
          <p:nvPr/>
        </p:nvSpPr>
        <p:spPr>
          <a:xfrm>
            <a:off x="1131914" y="5162760"/>
            <a:ext cx="1967205" cy="520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Condition : P = 0.020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Time:         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Condition × Time: P = &lt;0.00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4ECCE09-852F-0C2E-E322-84E0E0E52030}"/>
              </a:ext>
            </a:extLst>
          </p:cNvPr>
          <p:cNvSpPr txBox="1"/>
          <p:nvPr/>
        </p:nvSpPr>
        <p:spPr>
          <a:xfrm>
            <a:off x="2339112" y="702127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A5FCCBA-F61B-10E3-84A7-124E154EBB1B}"/>
              </a:ext>
            </a:extLst>
          </p:cNvPr>
          <p:cNvSpPr txBox="1"/>
          <p:nvPr/>
        </p:nvSpPr>
        <p:spPr>
          <a:xfrm>
            <a:off x="2822682" y="6460325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6688E72-51FA-C054-D9C6-6F344139D695}"/>
              </a:ext>
            </a:extLst>
          </p:cNvPr>
          <p:cNvSpPr txBox="1"/>
          <p:nvPr/>
        </p:nvSpPr>
        <p:spPr>
          <a:xfrm rot="16200000">
            <a:off x="140489" y="6294693"/>
            <a:ext cx="981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ESQ-C (AU)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62C77B1E-1DED-99F3-2758-69AD1A73C8F3}"/>
              </a:ext>
            </a:extLst>
          </p:cNvPr>
          <p:cNvCxnSpPr>
            <a:cxnSpLocks/>
          </p:cNvCxnSpPr>
          <p:nvPr/>
        </p:nvCxnSpPr>
        <p:spPr>
          <a:xfrm flipV="1">
            <a:off x="1525180" y="7579790"/>
            <a:ext cx="491358" cy="115087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C2D1E069-65BE-8622-30E4-679B3850865B}"/>
              </a:ext>
            </a:extLst>
          </p:cNvPr>
          <p:cNvCxnSpPr>
            <a:cxnSpLocks/>
          </p:cNvCxnSpPr>
          <p:nvPr/>
        </p:nvCxnSpPr>
        <p:spPr>
          <a:xfrm>
            <a:off x="2046914" y="7586863"/>
            <a:ext cx="409405" cy="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9299A0ED-0527-5084-3D88-70EBF94C3008}"/>
              </a:ext>
            </a:extLst>
          </p:cNvPr>
          <p:cNvCxnSpPr>
            <a:cxnSpLocks/>
          </p:cNvCxnSpPr>
          <p:nvPr/>
        </p:nvCxnSpPr>
        <p:spPr>
          <a:xfrm>
            <a:off x="2496244" y="7591121"/>
            <a:ext cx="454456" cy="7001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857A70F2-41C7-676A-2A96-140537B88048}"/>
              </a:ext>
            </a:extLst>
          </p:cNvPr>
          <p:cNvCxnSpPr>
            <a:cxnSpLocks/>
          </p:cNvCxnSpPr>
          <p:nvPr/>
        </p:nvCxnSpPr>
        <p:spPr>
          <a:xfrm>
            <a:off x="1316602" y="7714702"/>
            <a:ext cx="468000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6A8C6219-7467-6842-3745-8F962D8EDC1B}"/>
              </a:ext>
            </a:extLst>
          </p:cNvPr>
          <p:cNvCxnSpPr>
            <a:cxnSpLocks/>
          </p:cNvCxnSpPr>
          <p:nvPr/>
        </p:nvCxnSpPr>
        <p:spPr>
          <a:xfrm flipV="1">
            <a:off x="2958091" y="7430312"/>
            <a:ext cx="487003" cy="164309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F51E16B5-CD07-334B-377F-41FEA5341765}"/>
              </a:ext>
            </a:extLst>
          </p:cNvPr>
          <p:cNvCxnSpPr>
            <a:cxnSpLocks/>
          </p:cNvCxnSpPr>
          <p:nvPr/>
        </p:nvCxnSpPr>
        <p:spPr>
          <a:xfrm flipV="1">
            <a:off x="3436449" y="7179455"/>
            <a:ext cx="483501" cy="238879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7546C77-F1F0-D880-5826-18BF97091280}"/>
              </a:ext>
            </a:extLst>
          </p:cNvPr>
          <p:cNvCxnSpPr>
            <a:cxnSpLocks/>
          </p:cNvCxnSpPr>
          <p:nvPr/>
        </p:nvCxnSpPr>
        <p:spPr>
          <a:xfrm flipV="1">
            <a:off x="3910601" y="7130363"/>
            <a:ext cx="456137" cy="54726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A477A333-EECC-16ED-E169-7E4772B89FC2}"/>
              </a:ext>
            </a:extLst>
          </p:cNvPr>
          <p:cNvCxnSpPr>
            <a:cxnSpLocks/>
          </p:cNvCxnSpPr>
          <p:nvPr/>
        </p:nvCxnSpPr>
        <p:spPr>
          <a:xfrm>
            <a:off x="1770862" y="7714702"/>
            <a:ext cx="502887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DA4BEA92-0E25-8A1B-926C-8F09CDFA9092}"/>
              </a:ext>
            </a:extLst>
          </p:cNvPr>
          <p:cNvCxnSpPr>
            <a:cxnSpLocks/>
          </p:cNvCxnSpPr>
          <p:nvPr/>
        </p:nvCxnSpPr>
        <p:spPr>
          <a:xfrm flipV="1">
            <a:off x="2294331" y="7681740"/>
            <a:ext cx="453509" cy="29499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52580711-202A-91C3-E3C8-6BF420F5D852}"/>
              </a:ext>
            </a:extLst>
          </p:cNvPr>
          <p:cNvCxnSpPr>
            <a:cxnSpLocks/>
          </p:cNvCxnSpPr>
          <p:nvPr/>
        </p:nvCxnSpPr>
        <p:spPr>
          <a:xfrm flipV="1">
            <a:off x="2811794" y="7671822"/>
            <a:ext cx="440810" cy="1983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7B975A1F-90E4-A0CE-6EDE-9D82C15C6623}"/>
              </a:ext>
            </a:extLst>
          </p:cNvPr>
          <p:cNvCxnSpPr>
            <a:cxnSpLocks/>
          </p:cNvCxnSpPr>
          <p:nvPr/>
        </p:nvCxnSpPr>
        <p:spPr>
          <a:xfrm flipV="1">
            <a:off x="3241190" y="7678850"/>
            <a:ext cx="481760" cy="570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0A32B125-0177-F85C-797C-D99C723E4104}"/>
              </a:ext>
            </a:extLst>
          </p:cNvPr>
          <p:cNvCxnSpPr>
            <a:cxnSpLocks/>
          </p:cNvCxnSpPr>
          <p:nvPr/>
        </p:nvCxnSpPr>
        <p:spPr>
          <a:xfrm>
            <a:off x="3724575" y="7682109"/>
            <a:ext cx="488295" cy="9467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2750B651-CD84-9FFA-2DAA-B7C1C97CA4FC}"/>
              </a:ext>
            </a:extLst>
          </p:cNvPr>
          <p:cNvSpPr txBox="1"/>
          <p:nvPr/>
        </p:nvSpPr>
        <p:spPr>
          <a:xfrm>
            <a:off x="3299239" y="6453765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A9607EB-1146-4CB3-07F2-7AF6E8601216}"/>
              </a:ext>
            </a:extLst>
          </p:cNvPr>
          <p:cNvSpPr txBox="1"/>
          <p:nvPr/>
        </p:nvSpPr>
        <p:spPr>
          <a:xfrm>
            <a:off x="3774095" y="5516487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6547E8F-8855-FB5A-53B9-A0483B6AE84E}"/>
              </a:ext>
            </a:extLst>
          </p:cNvPr>
          <p:cNvSpPr txBox="1"/>
          <p:nvPr/>
        </p:nvSpPr>
        <p:spPr>
          <a:xfrm>
            <a:off x="4250272" y="5423184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6170473-10DE-484D-6890-7BA8AAB96A83}"/>
              </a:ext>
            </a:extLst>
          </p:cNvPr>
          <p:cNvSpPr txBox="1"/>
          <p:nvPr/>
        </p:nvSpPr>
        <p:spPr>
          <a:xfrm>
            <a:off x="259090" y="9350621"/>
            <a:ext cx="4539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+mj-lt"/>
              </a:rPr>
              <a:t>C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F77EE6F-8A7A-269A-59BC-63C61FCA930C}"/>
              </a:ext>
            </a:extLst>
          </p:cNvPr>
          <p:cNvSpPr txBox="1"/>
          <p:nvPr/>
        </p:nvSpPr>
        <p:spPr>
          <a:xfrm>
            <a:off x="2569754" y="12443870"/>
            <a:ext cx="609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Hours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BA10F78-5FB5-20E7-EA20-5E7BB88457EE}"/>
              </a:ext>
            </a:extLst>
          </p:cNvPr>
          <p:cNvSpPr txBox="1"/>
          <p:nvPr/>
        </p:nvSpPr>
        <p:spPr>
          <a:xfrm>
            <a:off x="1164523" y="9491615"/>
            <a:ext cx="1967205" cy="520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Condition : P = 0.028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Time:          P = &lt;0.001</a:t>
            </a:r>
          </a:p>
          <a:p>
            <a:pPr>
              <a:lnSpc>
                <a:spcPts val="1140"/>
              </a:lnSpc>
            </a:pP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Condition × Time: P = &lt;0.00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8449882-50A0-5FD3-B0F4-58F516DA9DC6}"/>
              </a:ext>
            </a:extLst>
          </p:cNvPr>
          <p:cNvSpPr txBox="1"/>
          <p:nvPr/>
        </p:nvSpPr>
        <p:spPr>
          <a:xfrm rot="16200000">
            <a:off x="218947" y="10623548"/>
            <a:ext cx="890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VAS (mm)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E2493BE4-958F-3A2A-E097-9AAF642387DE}"/>
              </a:ext>
            </a:extLst>
          </p:cNvPr>
          <p:cNvCxnSpPr>
            <a:cxnSpLocks/>
          </p:cNvCxnSpPr>
          <p:nvPr/>
        </p:nvCxnSpPr>
        <p:spPr>
          <a:xfrm flipV="1">
            <a:off x="1554492" y="11752246"/>
            <a:ext cx="480495" cy="259342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4506E249-82A7-4AF8-27CF-8D6F383D52FA}"/>
              </a:ext>
            </a:extLst>
          </p:cNvPr>
          <p:cNvCxnSpPr>
            <a:cxnSpLocks/>
          </p:cNvCxnSpPr>
          <p:nvPr/>
        </p:nvCxnSpPr>
        <p:spPr>
          <a:xfrm>
            <a:off x="2021351" y="11754894"/>
            <a:ext cx="483265" cy="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6EB18907-2BE1-5F63-D268-8C0C34D158AB}"/>
              </a:ext>
            </a:extLst>
          </p:cNvPr>
          <p:cNvCxnSpPr>
            <a:cxnSpLocks/>
          </p:cNvCxnSpPr>
          <p:nvPr/>
        </p:nvCxnSpPr>
        <p:spPr>
          <a:xfrm flipV="1">
            <a:off x="2518576" y="11658950"/>
            <a:ext cx="490699" cy="93299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C5328200-CFD5-60A5-95EA-9BA83BED8F28}"/>
              </a:ext>
            </a:extLst>
          </p:cNvPr>
          <p:cNvCxnSpPr>
            <a:cxnSpLocks/>
          </p:cNvCxnSpPr>
          <p:nvPr/>
        </p:nvCxnSpPr>
        <p:spPr>
          <a:xfrm>
            <a:off x="2979648" y="11660513"/>
            <a:ext cx="502425" cy="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2B43CCCA-760D-1648-C6BA-3791E84478A9}"/>
              </a:ext>
            </a:extLst>
          </p:cNvPr>
          <p:cNvCxnSpPr>
            <a:cxnSpLocks/>
          </p:cNvCxnSpPr>
          <p:nvPr/>
        </p:nvCxnSpPr>
        <p:spPr>
          <a:xfrm flipV="1">
            <a:off x="3472198" y="11317138"/>
            <a:ext cx="470944" cy="347771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F2CADCC2-5056-A8A4-0E04-569A8912C0EC}"/>
              </a:ext>
            </a:extLst>
          </p:cNvPr>
          <p:cNvCxnSpPr>
            <a:cxnSpLocks/>
          </p:cNvCxnSpPr>
          <p:nvPr/>
        </p:nvCxnSpPr>
        <p:spPr>
          <a:xfrm flipV="1">
            <a:off x="3943145" y="11222491"/>
            <a:ext cx="478609" cy="91986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911C6FAF-4D2D-A547-47C4-E0EB7F2DB996}"/>
              </a:ext>
            </a:extLst>
          </p:cNvPr>
          <p:cNvCxnSpPr>
            <a:cxnSpLocks/>
          </p:cNvCxnSpPr>
          <p:nvPr/>
        </p:nvCxnSpPr>
        <p:spPr>
          <a:xfrm flipV="1">
            <a:off x="1340025" y="11962630"/>
            <a:ext cx="493584" cy="73994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F0843E06-818F-328F-EFE1-495DDFE3020A}"/>
              </a:ext>
            </a:extLst>
          </p:cNvPr>
          <p:cNvCxnSpPr>
            <a:cxnSpLocks/>
          </p:cNvCxnSpPr>
          <p:nvPr/>
        </p:nvCxnSpPr>
        <p:spPr>
          <a:xfrm flipV="1">
            <a:off x="1833612" y="11952226"/>
            <a:ext cx="460719" cy="10407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B5E6161E-5195-4902-04CF-EAF240F8D1F5}"/>
              </a:ext>
            </a:extLst>
          </p:cNvPr>
          <p:cNvCxnSpPr>
            <a:cxnSpLocks/>
          </p:cNvCxnSpPr>
          <p:nvPr/>
        </p:nvCxnSpPr>
        <p:spPr>
          <a:xfrm flipV="1">
            <a:off x="2321871" y="11856941"/>
            <a:ext cx="464549" cy="95285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B192C032-00FC-BAD1-EF21-DD528AE5867E}"/>
              </a:ext>
            </a:extLst>
          </p:cNvPr>
          <p:cNvCxnSpPr>
            <a:cxnSpLocks/>
          </p:cNvCxnSpPr>
          <p:nvPr/>
        </p:nvCxnSpPr>
        <p:spPr>
          <a:xfrm>
            <a:off x="2772986" y="11858891"/>
            <a:ext cx="48621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E33E32E2-D5C6-1578-C1F5-1170AB1FB901}"/>
              </a:ext>
            </a:extLst>
          </p:cNvPr>
          <p:cNvCxnSpPr>
            <a:cxnSpLocks/>
          </p:cNvCxnSpPr>
          <p:nvPr/>
        </p:nvCxnSpPr>
        <p:spPr>
          <a:xfrm>
            <a:off x="3259196" y="11851318"/>
            <a:ext cx="463754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C82A6014-F06A-D3C3-018F-6A2E02883CE7}"/>
              </a:ext>
            </a:extLst>
          </p:cNvPr>
          <p:cNvCxnSpPr>
            <a:cxnSpLocks/>
          </p:cNvCxnSpPr>
          <p:nvPr/>
        </p:nvCxnSpPr>
        <p:spPr>
          <a:xfrm>
            <a:off x="3720095" y="11852555"/>
            <a:ext cx="492772" cy="68086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ADEC3E72-93BF-5BC4-DA01-609660CD78B3}"/>
              </a:ext>
            </a:extLst>
          </p:cNvPr>
          <p:cNvSpPr txBox="1"/>
          <p:nvPr/>
        </p:nvSpPr>
        <p:spPr>
          <a:xfrm>
            <a:off x="3802317" y="9567373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4793C38-D978-5C4B-CAEA-A49788B8FDC9}"/>
              </a:ext>
            </a:extLst>
          </p:cNvPr>
          <p:cNvSpPr txBox="1"/>
          <p:nvPr/>
        </p:nvSpPr>
        <p:spPr>
          <a:xfrm>
            <a:off x="4280189" y="9396050"/>
            <a:ext cx="2917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Calibri Light" panose="020F0302020204030204" pitchFamily="34" charset="0"/>
                <a:cs typeface="Calibri Light" panose="020F0302020204030204" pitchFamily="34" charset="0"/>
              </a:rPr>
              <a:t>†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F228296B-0B38-A504-52BD-CE743AA088FB}"/>
              </a:ext>
            </a:extLst>
          </p:cNvPr>
          <p:cNvSpPr txBox="1"/>
          <p:nvPr/>
        </p:nvSpPr>
        <p:spPr>
          <a:xfrm>
            <a:off x="10722064" y="5109861"/>
            <a:ext cx="981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AMS+ (n = 5)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E51C3D07-EF74-0CDA-ECDF-A4A3A8627E0A}"/>
              </a:ext>
            </a:extLst>
          </p:cNvPr>
          <p:cNvSpPr txBox="1"/>
          <p:nvPr/>
        </p:nvSpPr>
        <p:spPr>
          <a:xfrm>
            <a:off x="10718903" y="5268593"/>
            <a:ext cx="98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AMS-  (n = 7)</a:t>
            </a:r>
          </a:p>
        </p:txBody>
      </p:sp>
      <p:pic>
        <p:nvPicPr>
          <p:cNvPr id="215" name="Picture 214">
            <a:extLst>
              <a:ext uri="{FF2B5EF4-FFF2-40B4-BE49-F238E27FC236}">
                <a16:creationId xmlns:a16="http://schemas.microsoft.com/office/drawing/2014/main" id="{271146BF-8072-D592-4FA1-2BC87B4DD6E2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672887" y="5184593"/>
            <a:ext cx="146050" cy="133350"/>
          </a:xfrm>
          <a:prstGeom prst="rect">
            <a:avLst/>
          </a:prstGeom>
        </p:spPr>
      </p:pic>
      <p:pic>
        <p:nvPicPr>
          <p:cNvPr id="216" name="Picture 215">
            <a:extLst>
              <a:ext uri="{FF2B5EF4-FFF2-40B4-BE49-F238E27FC236}">
                <a16:creationId xmlns:a16="http://schemas.microsoft.com/office/drawing/2014/main" id="{31D8DB87-A9A4-BB32-A49D-9D5A1B1CF559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670272" y="5328682"/>
            <a:ext cx="139700" cy="146050"/>
          </a:xfrm>
          <a:prstGeom prst="rect">
            <a:avLst/>
          </a:prstGeom>
        </p:spPr>
      </p:pic>
      <p:sp>
        <p:nvSpPr>
          <p:cNvPr id="217" name="TextBox 216">
            <a:extLst>
              <a:ext uri="{FF2B5EF4-FFF2-40B4-BE49-F238E27FC236}">
                <a16:creationId xmlns:a16="http://schemas.microsoft.com/office/drawing/2014/main" id="{9580B494-C967-3889-83F2-28B1013239A3}"/>
              </a:ext>
            </a:extLst>
          </p:cNvPr>
          <p:cNvSpPr txBox="1"/>
          <p:nvPr/>
        </p:nvSpPr>
        <p:spPr>
          <a:xfrm>
            <a:off x="10722064" y="9422092"/>
            <a:ext cx="981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AMS+ (n = 5)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2235605F-5B01-5910-4BDF-9C4F696A85AB}"/>
              </a:ext>
            </a:extLst>
          </p:cNvPr>
          <p:cNvSpPr txBox="1"/>
          <p:nvPr/>
        </p:nvSpPr>
        <p:spPr>
          <a:xfrm>
            <a:off x="10718903" y="9580824"/>
            <a:ext cx="98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AMS-  (n = 7)</a:t>
            </a:r>
          </a:p>
        </p:txBody>
      </p:sp>
      <p:pic>
        <p:nvPicPr>
          <p:cNvPr id="219" name="Picture 218">
            <a:extLst>
              <a:ext uri="{FF2B5EF4-FFF2-40B4-BE49-F238E27FC236}">
                <a16:creationId xmlns:a16="http://schemas.microsoft.com/office/drawing/2014/main" id="{0864F774-1B9A-F70C-F1DB-AE1A4636C881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672887" y="9496824"/>
            <a:ext cx="146050" cy="133350"/>
          </a:xfrm>
          <a:prstGeom prst="rect">
            <a:avLst/>
          </a:prstGeom>
        </p:spPr>
      </p:pic>
      <p:pic>
        <p:nvPicPr>
          <p:cNvPr id="224" name="Picture 223">
            <a:extLst>
              <a:ext uri="{FF2B5EF4-FFF2-40B4-BE49-F238E27FC236}">
                <a16:creationId xmlns:a16="http://schemas.microsoft.com/office/drawing/2014/main" id="{7C023837-DCC6-51F8-C79A-471F9FEEF814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670272" y="9640913"/>
            <a:ext cx="139700" cy="146050"/>
          </a:xfrm>
          <a:prstGeom prst="rect">
            <a:avLst/>
          </a:prstGeom>
        </p:spPr>
      </p:pic>
      <p:sp>
        <p:nvSpPr>
          <p:cNvPr id="225" name="TextBox 224">
            <a:extLst>
              <a:ext uri="{FF2B5EF4-FFF2-40B4-BE49-F238E27FC236}">
                <a16:creationId xmlns:a16="http://schemas.microsoft.com/office/drawing/2014/main" id="{379635E6-B9FD-866B-1DC4-AFDBF6000C4D}"/>
              </a:ext>
            </a:extLst>
          </p:cNvPr>
          <p:cNvSpPr txBox="1"/>
          <p:nvPr/>
        </p:nvSpPr>
        <p:spPr>
          <a:xfrm>
            <a:off x="4795676" y="832176"/>
            <a:ext cx="1297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alibri Light" panose="020F0302020204030204" pitchFamily="34" charset="0"/>
                <a:cs typeface="Calibri Light" panose="020F0302020204030204" pitchFamily="34" charset="0"/>
              </a:rPr>
              <a:t>Normoxia</a:t>
            </a: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 (n = 12)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A406CD27-B116-4578-C167-FD3FF7317EC7}"/>
              </a:ext>
            </a:extLst>
          </p:cNvPr>
          <p:cNvSpPr txBox="1"/>
          <p:nvPr/>
        </p:nvSpPr>
        <p:spPr>
          <a:xfrm>
            <a:off x="4792515" y="997632"/>
            <a:ext cx="12925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Hypoxia    (n = 12)</a:t>
            </a:r>
          </a:p>
        </p:txBody>
      </p:sp>
      <p:sp>
        <p:nvSpPr>
          <p:cNvPr id="229" name="Oval 228">
            <a:extLst>
              <a:ext uri="{FF2B5EF4-FFF2-40B4-BE49-F238E27FC236}">
                <a16:creationId xmlns:a16="http://schemas.microsoft.com/office/drawing/2014/main" id="{3DF0B97A-000C-C0EA-11D4-8C6CC5ABAFC5}"/>
              </a:ext>
            </a:extLst>
          </p:cNvPr>
          <p:cNvSpPr/>
          <p:nvPr/>
        </p:nvSpPr>
        <p:spPr>
          <a:xfrm>
            <a:off x="4755535" y="1089181"/>
            <a:ext cx="98010" cy="93899"/>
          </a:xfrm>
          <a:prstGeom prst="ellipse">
            <a:avLst/>
          </a:prstGeom>
          <a:solidFill>
            <a:schemeClr val="bg1">
              <a:lumMod val="50000"/>
            </a:schemeClr>
          </a:solidFill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Oval 229">
            <a:extLst>
              <a:ext uri="{FF2B5EF4-FFF2-40B4-BE49-F238E27FC236}">
                <a16:creationId xmlns:a16="http://schemas.microsoft.com/office/drawing/2014/main" id="{690F1F6F-4D84-FD85-54F4-FE8021A1E7E6}"/>
              </a:ext>
            </a:extLst>
          </p:cNvPr>
          <p:cNvSpPr/>
          <p:nvPr/>
        </p:nvSpPr>
        <p:spPr>
          <a:xfrm>
            <a:off x="4755535" y="923477"/>
            <a:ext cx="98010" cy="93899"/>
          </a:xfrm>
          <a:prstGeom prst="ellipse">
            <a:avLst/>
          </a:prstGeom>
          <a:solidFill>
            <a:schemeClr val="bg1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6B7C73EF-178D-77C1-CC71-F69A455D1C5E}"/>
              </a:ext>
            </a:extLst>
          </p:cNvPr>
          <p:cNvSpPr txBox="1"/>
          <p:nvPr/>
        </p:nvSpPr>
        <p:spPr>
          <a:xfrm>
            <a:off x="4801534" y="5071087"/>
            <a:ext cx="1297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alibri Light" panose="020F0302020204030204" pitchFamily="34" charset="0"/>
                <a:cs typeface="Calibri Light" panose="020F0302020204030204" pitchFamily="34" charset="0"/>
              </a:rPr>
              <a:t>Normoxia</a:t>
            </a: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 (n = 12)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94E779D7-5A61-40BE-732F-6C1F0F7EB213}"/>
              </a:ext>
            </a:extLst>
          </p:cNvPr>
          <p:cNvSpPr txBox="1"/>
          <p:nvPr/>
        </p:nvSpPr>
        <p:spPr>
          <a:xfrm>
            <a:off x="4798373" y="5236543"/>
            <a:ext cx="12925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Hypoxia    (n = 12)</a:t>
            </a:r>
          </a:p>
        </p:txBody>
      </p:sp>
      <p:sp>
        <p:nvSpPr>
          <p:cNvPr id="233" name="Oval 232">
            <a:extLst>
              <a:ext uri="{FF2B5EF4-FFF2-40B4-BE49-F238E27FC236}">
                <a16:creationId xmlns:a16="http://schemas.microsoft.com/office/drawing/2014/main" id="{38524A45-8ECD-ED75-A37E-E921E0C7D667}"/>
              </a:ext>
            </a:extLst>
          </p:cNvPr>
          <p:cNvSpPr/>
          <p:nvPr/>
        </p:nvSpPr>
        <p:spPr>
          <a:xfrm>
            <a:off x="4761393" y="5328092"/>
            <a:ext cx="98010" cy="93899"/>
          </a:xfrm>
          <a:prstGeom prst="ellipse">
            <a:avLst/>
          </a:prstGeom>
          <a:solidFill>
            <a:schemeClr val="bg1">
              <a:lumMod val="50000"/>
            </a:schemeClr>
          </a:solidFill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Oval 233">
            <a:extLst>
              <a:ext uri="{FF2B5EF4-FFF2-40B4-BE49-F238E27FC236}">
                <a16:creationId xmlns:a16="http://schemas.microsoft.com/office/drawing/2014/main" id="{5061760D-7FF9-6141-C7E0-E22EE5087ABE}"/>
              </a:ext>
            </a:extLst>
          </p:cNvPr>
          <p:cNvSpPr/>
          <p:nvPr/>
        </p:nvSpPr>
        <p:spPr>
          <a:xfrm>
            <a:off x="4761393" y="5162388"/>
            <a:ext cx="98010" cy="93899"/>
          </a:xfrm>
          <a:prstGeom prst="ellipse">
            <a:avLst/>
          </a:prstGeom>
          <a:solidFill>
            <a:schemeClr val="bg1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5AFE99DE-0056-AB33-C845-39C43230B2F4}"/>
              </a:ext>
            </a:extLst>
          </p:cNvPr>
          <p:cNvSpPr txBox="1"/>
          <p:nvPr/>
        </p:nvSpPr>
        <p:spPr>
          <a:xfrm>
            <a:off x="4807559" y="9401920"/>
            <a:ext cx="1297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alibri Light" panose="020F0302020204030204" pitchFamily="34" charset="0"/>
                <a:cs typeface="Calibri Light" panose="020F0302020204030204" pitchFamily="34" charset="0"/>
              </a:rPr>
              <a:t>Normoxia</a:t>
            </a:r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 (n = 12)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13C549DB-8CFD-A31F-2E2B-31D5F78FA06B}"/>
              </a:ext>
            </a:extLst>
          </p:cNvPr>
          <p:cNvSpPr txBox="1"/>
          <p:nvPr/>
        </p:nvSpPr>
        <p:spPr>
          <a:xfrm>
            <a:off x="4804398" y="9567376"/>
            <a:ext cx="12925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 Light" panose="020F0302020204030204" pitchFamily="34" charset="0"/>
                <a:cs typeface="Calibri Light" panose="020F0302020204030204" pitchFamily="34" charset="0"/>
              </a:rPr>
              <a:t>Hypoxia    (n = 12)</a:t>
            </a:r>
          </a:p>
        </p:txBody>
      </p:sp>
      <p:sp>
        <p:nvSpPr>
          <p:cNvPr id="239" name="Oval 238">
            <a:extLst>
              <a:ext uri="{FF2B5EF4-FFF2-40B4-BE49-F238E27FC236}">
                <a16:creationId xmlns:a16="http://schemas.microsoft.com/office/drawing/2014/main" id="{EB1C9879-506A-1F7D-8517-E4B8D62CD769}"/>
              </a:ext>
            </a:extLst>
          </p:cNvPr>
          <p:cNvSpPr/>
          <p:nvPr/>
        </p:nvSpPr>
        <p:spPr>
          <a:xfrm>
            <a:off x="4767418" y="9658925"/>
            <a:ext cx="98010" cy="93899"/>
          </a:xfrm>
          <a:prstGeom prst="ellipse">
            <a:avLst/>
          </a:prstGeom>
          <a:solidFill>
            <a:schemeClr val="bg1">
              <a:lumMod val="50000"/>
            </a:schemeClr>
          </a:solidFill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Oval 239">
            <a:extLst>
              <a:ext uri="{FF2B5EF4-FFF2-40B4-BE49-F238E27FC236}">
                <a16:creationId xmlns:a16="http://schemas.microsoft.com/office/drawing/2014/main" id="{7B808052-FAD7-97BE-1977-DBEB92F6096D}"/>
              </a:ext>
            </a:extLst>
          </p:cNvPr>
          <p:cNvSpPr/>
          <p:nvPr/>
        </p:nvSpPr>
        <p:spPr>
          <a:xfrm>
            <a:off x="4767418" y="9493221"/>
            <a:ext cx="98010" cy="93899"/>
          </a:xfrm>
          <a:prstGeom prst="ellipse">
            <a:avLst/>
          </a:prstGeom>
          <a:solidFill>
            <a:schemeClr val="bg1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1113320-7C50-7D71-A5A0-ADAE5652EDA6}"/>
              </a:ext>
            </a:extLst>
          </p:cNvPr>
          <p:cNvSpPr txBox="1"/>
          <p:nvPr/>
        </p:nvSpPr>
        <p:spPr>
          <a:xfrm>
            <a:off x="1528719" y="259368"/>
            <a:ext cx="2356693" cy="369332"/>
          </a:xfrm>
          <a:prstGeom prst="rect">
            <a:avLst/>
          </a:prstGeom>
          <a:solidFill>
            <a:schemeClr val="tx1"/>
          </a:solidFill>
          <a:effectLst>
            <a:softEdge rad="254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Pooled dat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DBEB47-9900-A41B-25CD-4712EC065755}"/>
              </a:ext>
            </a:extLst>
          </p:cNvPr>
          <p:cNvSpPr txBox="1"/>
          <p:nvPr/>
        </p:nvSpPr>
        <p:spPr>
          <a:xfrm>
            <a:off x="7563676" y="257159"/>
            <a:ext cx="2356693" cy="369332"/>
          </a:xfrm>
          <a:prstGeom prst="rect">
            <a:avLst/>
          </a:prstGeom>
          <a:solidFill>
            <a:schemeClr val="bg1">
              <a:lumMod val="50000"/>
            </a:schemeClr>
          </a:solidFill>
          <a:effectLst>
            <a:softEdge rad="254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AMS data</a:t>
            </a: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6A06792D-4156-A57C-05C2-BA134F1CCE61}"/>
              </a:ext>
            </a:extLst>
          </p:cNvPr>
          <p:cNvCxnSpPr>
            <a:cxnSpLocks/>
          </p:cNvCxnSpPr>
          <p:nvPr/>
        </p:nvCxnSpPr>
        <p:spPr>
          <a:xfrm>
            <a:off x="7077770" y="1924525"/>
            <a:ext cx="3456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69AF901E-5CBF-F97D-17D3-5D2E9C0F390C}"/>
              </a:ext>
            </a:extLst>
          </p:cNvPr>
          <p:cNvCxnSpPr>
            <a:cxnSpLocks/>
          </p:cNvCxnSpPr>
          <p:nvPr/>
        </p:nvCxnSpPr>
        <p:spPr>
          <a:xfrm>
            <a:off x="7062140" y="7137103"/>
            <a:ext cx="3456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lg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0754F8B5-6FC5-D7E7-6D3A-647BF2E3A9CB}"/>
              </a:ext>
            </a:extLst>
          </p:cNvPr>
          <p:cNvSpPr txBox="1"/>
          <p:nvPr/>
        </p:nvSpPr>
        <p:spPr>
          <a:xfrm>
            <a:off x="10534365" y="1763935"/>
            <a:ext cx="677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Cut-off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B92CF698-D0A0-8E7E-02D2-0422C05F7FD1}"/>
              </a:ext>
            </a:extLst>
          </p:cNvPr>
          <p:cNvSpPr txBox="1"/>
          <p:nvPr/>
        </p:nvSpPr>
        <p:spPr>
          <a:xfrm>
            <a:off x="10536805" y="6971384"/>
            <a:ext cx="677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Cut-off</a:t>
            </a:r>
          </a:p>
        </p:txBody>
      </p:sp>
    </p:spTree>
    <p:extLst>
      <p:ext uri="{BB962C8B-B14F-4D97-AF65-F5344CB8AC3E}">
        <p14:creationId xmlns:p14="http://schemas.microsoft.com/office/powerpoint/2010/main" val="2970761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0D9CBF0C-F519-184B-B0AE-7639BEACBF8A}">
  <we:reference id="wa200006038" version="1.0.0.3" store="en-US" storeType="OMEX"/>
  <we:alternateReferences>
    <we:reference id="WA200006038" version="1.0.0.3" store="" storeType="OMEX"/>
  </we:alternateReferences>
  <we:properties>
    <we:property name="has-user-completed-add" value="true"/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Metadata/LabelInfo.xml><?xml version="1.0" encoding="utf-8"?>
<clbl:labelList xmlns:clbl="http://schemas.microsoft.com/office/2020/mipLabelMetadata">
  <clbl:label id="{553f0066-c24e-444c-9c2a-7427c31ebeab}" enabled="1" method="Standard" siteId="{e5aafe7c-971b-4ab7-b039-141ad36acec0}" contentBits="1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7</TotalTime>
  <Words>266</Words>
  <Application>Microsoft Macintosh PowerPoint</Application>
  <PresentationFormat>Custom</PresentationFormat>
  <Paragraphs>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Calibri Light</vt:lpstr>
      <vt:lpstr>Office Theme</vt:lpstr>
      <vt:lpstr>PowerPoint Presentation</vt:lpstr>
    </vt:vector>
  </TitlesOfParts>
  <Company>University of South Wal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jamin Stacey</dc:creator>
  <cp:lastModifiedBy>Damian Bailey</cp:lastModifiedBy>
  <cp:revision>63</cp:revision>
  <dcterms:created xsi:type="dcterms:W3CDTF">2024-07-03T00:06:06Z</dcterms:created>
  <dcterms:modified xsi:type="dcterms:W3CDTF">2025-02-08T10:39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lassificationContentMarkingHeaderLocations">
    <vt:lpwstr>Office Theme:8</vt:lpwstr>
  </property>
  <property fmtid="{D5CDD505-2E9C-101B-9397-08002B2CF9AE}" pid="3" name="ClassificationContentMarkingHeaderText">
    <vt:lpwstr>PUBLIC / CYHOEDDUS</vt:lpwstr>
  </property>
</Properties>
</file>